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5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 smtClean="0"/>
              <a:t>Over 20</a:t>
            </a:r>
            <a:r>
              <a:rPr lang="en-US" baseline="0" dirty="0" smtClean="0"/>
              <a:t> years ol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7473392710982284E-2"/>
          <c:y val="0.1018241469816273"/>
          <c:w val="0.89320434268031346"/>
          <c:h val="0.74557830271216097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The number of influenza cases per week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C$2:$C$314</c:f>
              <c:numCache>
                <c:formatCode>General</c:formatCode>
                <c:ptCount val="313"/>
                <c:pt idx="0">
                  <c:v>502</c:v>
                </c:pt>
                <c:pt idx="1">
                  <c:v>521</c:v>
                </c:pt>
                <c:pt idx="2">
                  <c:v>1074</c:v>
                </c:pt>
                <c:pt idx="3">
                  <c:v>1633</c:v>
                </c:pt>
                <c:pt idx="4">
                  <c:v>1911</c:v>
                </c:pt>
                <c:pt idx="5">
                  <c:v>1606</c:v>
                </c:pt>
                <c:pt idx="6">
                  <c:v>1270</c:v>
                </c:pt>
                <c:pt idx="7">
                  <c:v>852</c:v>
                </c:pt>
                <c:pt idx="8">
                  <c:v>598</c:v>
                </c:pt>
                <c:pt idx="9">
                  <c:v>490</c:v>
                </c:pt>
                <c:pt idx="10">
                  <c:v>363</c:v>
                </c:pt>
                <c:pt idx="11">
                  <c:v>455</c:v>
                </c:pt>
                <c:pt idx="12">
                  <c:v>427</c:v>
                </c:pt>
                <c:pt idx="13">
                  <c:v>301</c:v>
                </c:pt>
                <c:pt idx="14">
                  <c:v>301</c:v>
                </c:pt>
                <c:pt idx="15">
                  <c:v>188</c:v>
                </c:pt>
                <c:pt idx="16">
                  <c:v>98</c:v>
                </c:pt>
                <c:pt idx="17">
                  <c:v>50</c:v>
                </c:pt>
                <c:pt idx="18">
                  <c:v>33</c:v>
                </c:pt>
                <c:pt idx="19">
                  <c:v>14</c:v>
                </c:pt>
                <c:pt idx="20">
                  <c:v>9</c:v>
                </c:pt>
                <c:pt idx="21">
                  <c:v>7</c:v>
                </c:pt>
                <c:pt idx="22">
                  <c:v>5</c:v>
                </c:pt>
                <c:pt idx="23">
                  <c:v>4</c:v>
                </c:pt>
                <c:pt idx="24">
                  <c:v>3</c:v>
                </c:pt>
                <c:pt idx="25">
                  <c:v>1</c:v>
                </c:pt>
                <c:pt idx="26">
                  <c:v>6</c:v>
                </c:pt>
                <c:pt idx="27">
                  <c:v>3</c:v>
                </c:pt>
                <c:pt idx="28">
                  <c:v>1</c:v>
                </c:pt>
                <c:pt idx="29">
                  <c:v>5</c:v>
                </c:pt>
                <c:pt idx="30">
                  <c:v>2</c:v>
                </c:pt>
                <c:pt idx="31">
                  <c:v>5</c:v>
                </c:pt>
                <c:pt idx="32">
                  <c:v>5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1</c:v>
                </c:pt>
                <c:pt idx="37">
                  <c:v>1</c:v>
                </c:pt>
                <c:pt idx="38">
                  <c:v>2</c:v>
                </c:pt>
                <c:pt idx="39">
                  <c:v>3</c:v>
                </c:pt>
                <c:pt idx="40">
                  <c:v>7</c:v>
                </c:pt>
                <c:pt idx="41">
                  <c:v>4</c:v>
                </c:pt>
                <c:pt idx="42">
                  <c:v>4</c:v>
                </c:pt>
                <c:pt idx="43">
                  <c:v>9</c:v>
                </c:pt>
                <c:pt idx="44">
                  <c:v>10</c:v>
                </c:pt>
                <c:pt idx="45">
                  <c:v>6</c:v>
                </c:pt>
                <c:pt idx="46">
                  <c:v>16</c:v>
                </c:pt>
                <c:pt idx="47">
                  <c:v>10</c:v>
                </c:pt>
                <c:pt idx="48">
                  <c:v>13</c:v>
                </c:pt>
                <c:pt idx="49">
                  <c:v>29</c:v>
                </c:pt>
                <c:pt idx="50">
                  <c:v>49</c:v>
                </c:pt>
                <c:pt idx="51">
                  <c:v>101</c:v>
                </c:pt>
                <c:pt idx="52">
                  <c:v>234</c:v>
                </c:pt>
                <c:pt idx="53">
                  <c:v>517</c:v>
                </c:pt>
                <c:pt idx="54">
                  <c:v>1073</c:v>
                </c:pt>
                <c:pt idx="55">
                  <c:v>1707</c:v>
                </c:pt>
                <c:pt idx="56">
                  <c:v>2135</c:v>
                </c:pt>
                <c:pt idx="57">
                  <c:v>1789</c:v>
                </c:pt>
                <c:pt idx="58">
                  <c:v>1236</c:v>
                </c:pt>
                <c:pt idx="59">
                  <c:v>987</c:v>
                </c:pt>
                <c:pt idx="60">
                  <c:v>712</c:v>
                </c:pt>
                <c:pt idx="61">
                  <c:v>530</c:v>
                </c:pt>
                <c:pt idx="62">
                  <c:v>323</c:v>
                </c:pt>
                <c:pt idx="63">
                  <c:v>282</c:v>
                </c:pt>
                <c:pt idx="64">
                  <c:v>222</c:v>
                </c:pt>
                <c:pt idx="65">
                  <c:v>153</c:v>
                </c:pt>
                <c:pt idx="66">
                  <c:v>102</c:v>
                </c:pt>
                <c:pt idx="67">
                  <c:v>131</c:v>
                </c:pt>
                <c:pt idx="68">
                  <c:v>117</c:v>
                </c:pt>
                <c:pt idx="69">
                  <c:v>84</c:v>
                </c:pt>
                <c:pt idx="70">
                  <c:v>110</c:v>
                </c:pt>
                <c:pt idx="71">
                  <c:v>77</c:v>
                </c:pt>
                <c:pt idx="72">
                  <c:v>55</c:v>
                </c:pt>
                <c:pt idx="73">
                  <c:v>27</c:v>
                </c:pt>
                <c:pt idx="74">
                  <c:v>20</c:v>
                </c:pt>
                <c:pt idx="75">
                  <c:v>6</c:v>
                </c:pt>
                <c:pt idx="76">
                  <c:v>3</c:v>
                </c:pt>
                <c:pt idx="77">
                  <c:v>2</c:v>
                </c:pt>
                <c:pt idx="78">
                  <c:v>1</c:v>
                </c:pt>
                <c:pt idx="79">
                  <c:v>2</c:v>
                </c:pt>
                <c:pt idx="80">
                  <c:v>2</c:v>
                </c:pt>
                <c:pt idx="81">
                  <c:v>2</c:v>
                </c:pt>
                <c:pt idx="82">
                  <c:v>3</c:v>
                </c:pt>
                <c:pt idx="83">
                  <c:v>0</c:v>
                </c:pt>
                <c:pt idx="84">
                  <c:v>1</c:v>
                </c:pt>
                <c:pt idx="85">
                  <c:v>5</c:v>
                </c:pt>
                <c:pt idx="86">
                  <c:v>2</c:v>
                </c:pt>
                <c:pt idx="87">
                  <c:v>1</c:v>
                </c:pt>
                <c:pt idx="88">
                  <c:v>2</c:v>
                </c:pt>
                <c:pt idx="89">
                  <c:v>4</c:v>
                </c:pt>
                <c:pt idx="90">
                  <c:v>1</c:v>
                </c:pt>
                <c:pt idx="91">
                  <c:v>5</c:v>
                </c:pt>
                <c:pt idx="92">
                  <c:v>2</c:v>
                </c:pt>
                <c:pt idx="93">
                  <c:v>4</c:v>
                </c:pt>
                <c:pt idx="94">
                  <c:v>3</c:v>
                </c:pt>
                <c:pt idx="95">
                  <c:v>6</c:v>
                </c:pt>
                <c:pt idx="96">
                  <c:v>10</c:v>
                </c:pt>
                <c:pt idx="97">
                  <c:v>10</c:v>
                </c:pt>
                <c:pt idx="98">
                  <c:v>11</c:v>
                </c:pt>
                <c:pt idx="99">
                  <c:v>28</c:v>
                </c:pt>
                <c:pt idx="100">
                  <c:v>36</c:v>
                </c:pt>
                <c:pt idx="101">
                  <c:v>37</c:v>
                </c:pt>
                <c:pt idx="102">
                  <c:v>60</c:v>
                </c:pt>
                <c:pt idx="103">
                  <c:v>134</c:v>
                </c:pt>
                <c:pt idx="104">
                  <c:v>278</c:v>
                </c:pt>
                <c:pt idx="105">
                  <c:v>598</c:v>
                </c:pt>
                <c:pt idx="106">
                  <c:v>1141</c:v>
                </c:pt>
                <c:pt idx="107">
                  <c:v>1813</c:v>
                </c:pt>
                <c:pt idx="108">
                  <c:v>2051</c:v>
                </c:pt>
                <c:pt idx="109">
                  <c:v>1521</c:v>
                </c:pt>
                <c:pt idx="110">
                  <c:v>1378</c:v>
                </c:pt>
                <c:pt idx="111">
                  <c:v>1098</c:v>
                </c:pt>
                <c:pt idx="112">
                  <c:v>1135</c:v>
                </c:pt>
                <c:pt idx="113">
                  <c:v>875</c:v>
                </c:pt>
                <c:pt idx="114">
                  <c:v>765</c:v>
                </c:pt>
                <c:pt idx="115">
                  <c:v>758</c:v>
                </c:pt>
                <c:pt idx="116">
                  <c:v>694</c:v>
                </c:pt>
                <c:pt idx="117">
                  <c:v>479</c:v>
                </c:pt>
                <c:pt idx="118">
                  <c:v>359</c:v>
                </c:pt>
                <c:pt idx="119">
                  <c:v>272</c:v>
                </c:pt>
                <c:pt idx="120">
                  <c:v>205</c:v>
                </c:pt>
                <c:pt idx="121">
                  <c:v>128</c:v>
                </c:pt>
                <c:pt idx="122">
                  <c:v>69</c:v>
                </c:pt>
                <c:pt idx="123">
                  <c:v>44</c:v>
                </c:pt>
                <c:pt idx="124">
                  <c:v>31</c:v>
                </c:pt>
                <c:pt idx="125">
                  <c:v>18</c:v>
                </c:pt>
                <c:pt idx="126">
                  <c:v>10</c:v>
                </c:pt>
                <c:pt idx="127">
                  <c:v>5</c:v>
                </c:pt>
                <c:pt idx="128">
                  <c:v>7</c:v>
                </c:pt>
                <c:pt idx="129">
                  <c:v>5</c:v>
                </c:pt>
                <c:pt idx="130">
                  <c:v>5</c:v>
                </c:pt>
                <c:pt idx="131">
                  <c:v>3</c:v>
                </c:pt>
                <c:pt idx="132">
                  <c:v>6</c:v>
                </c:pt>
                <c:pt idx="133">
                  <c:v>6</c:v>
                </c:pt>
                <c:pt idx="134">
                  <c:v>3</c:v>
                </c:pt>
                <c:pt idx="135">
                  <c:v>3</c:v>
                </c:pt>
                <c:pt idx="136">
                  <c:v>5</c:v>
                </c:pt>
                <c:pt idx="137">
                  <c:v>3</c:v>
                </c:pt>
                <c:pt idx="138">
                  <c:v>4</c:v>
                </c:pt>
                <c:pt idx="139">
                  <c:v>3</c:v>
                </c:pt>
                <c:pt idx="140">
                  <c:v>3</c:v>
                </c:pt>
                <c:pt idx="141">
                  <c:v>3</c:v>
                </c:pt>
                <c:pt idx="142">
                  <c:v>3</c:v>
                </c:pt>
                <c:pt idx="143">
                  <c:v>5</c:v>
                </c:pt>
                <c:pt idx="144">
                  <c:v>5</c:v>
                </c:pt>
                <c:pt idx="145">
                  <c:v>2</c:v>
                </c:pt>
                <c:pt idx="146">
                  <c:v>7</c:v>
                </c:pt>
                <c:pt idx="147">
                  <c:v>7</c:v>
                </c:pt>
                <c:pt idx="148">
                  <c:v>17</c:v>
                </c:pt>
                <c:pt idx="149">
                  <c:v>19</c:v>
                </c:pt>
                <c:pt idx="150">
                  <c:v>40</c:v>
                </c:pt>
                <c:pt idx="151">
                  <c:v>83</c:v>
                </c:pt>
                <c:pt idx="152">
                  <c:v>126</c:v>
                </c:pt>
                <c:pt idx="153">
                  <c:v>295</c:v>
                </c:pt>
                <c:pt idx="154">
                  <c:v>752</c:v>
                </c:pt>
                <c:pt idx="155">
                  <c:v>1947</c:v>
                </c:pt>
                <c:pt idx="156">
                  <c:v>2669</c:v>
                </c:pt>
                <c:pt idx="157">
                  <c:v>2985</c:v>
                </c:pt>
                <c:pt idx="158">
                  <c:v>2243</c:v>
                </c:pt>
                <c:pt idx="159">
                  <c:v>1742</c:v>
                </c:pt>
                <c:pt idx="160">
                  <c:v>1176</c:v>
                </c:pt>
                <c:pt idx="161">
                  <c:v>733</c:v>
                </c:pt>
                <c:pt idx="162">
                  <c:v>489</c:v>
                </c:pt>
                <c:pt idx="163">
                  <c:v>325</c:v>
                </c:pt>
                <c:pt idx="164">
                  <c:v>305</c:v>
                </c:pt>
                <c:pt idx="165">
                  <c:v>208</c:v>
                </c:pt>
                <c:pt idx="166">
                  <c:v>209</c:v>
                </c:pt>
                <c:pt idx="167">
                  <c:v>197</c:v>
                </c:pt>
                <c:pt idx="168">
                  <c:v>152</c:v>
                </c:pt>
                <c:pt idx="169">
                  <c:v>181</c:v>
                </c:pt>
                <c:pt idx="170">
                  <c:v>115</c:v>
                </c:pt>
                <c:pt idx="171">
                  <c:v>111</c:v>
                </c:pt>
                <c:pt idx="172">
                  <c:v>103</c:v>
                </c:pt>
                <c:pt idx="173">
                  <c:v>91</c:v>
                </c:pt>
                <c:pt idx="174">
                  <c:v>54</c:v>
                </c:pt>
                <c:pt idx="175">
                  <c:v>28</c:v>
                </c:pt>
                <c:pt idx="176">
                  <c:v>15</c:v>
                </c:pt>
                <c:pt idx="177">
                  <c:v>14</c:v>
                </c:pt>
                <c:pt idx="178">
                  <c:v>13</c:v>
                </c:pt>
                <c:pt idx="179">
                  <c:v>7</c:v>
                </c:pt>
                <c:pt idx="180">
                  <c:v>4</c:v>
                </c:pt>
                <c:pt idx="181">
                  <c:v>4</c:v>
                </c:pt>
                <c:pt idx="182">
                  <c:v>4</c:v>
                </c:pt>
                <c:pt idx="183">
                  <c:v>5</c:v>
                </c:pt>
                <c:pt idx="184">
                  <c:v>5</c:v>
                </c:pt>
                <c:pt idx="185">
                  <c:v>7</c:v>
                </c:pt>
                <c:pt idx="186">
                  <c:v>5</c:v>
                </c:pt>
                <c:pt idx="187">
                  <c:v>3</c:v>
                </c:pt>
                <c:pt idx="188">
                  <c:v>4</c:v>
                </c:pt>
                <c:pt idx="189">
                  <c:v>4</c:v>
                </c:pt>
                <c:pt idx="190">
                  <c:v>5</c:v>
                </c:pt>
                <c:pt idx="191">
                  <c:v>3</c:v>
                </c:pt>
                <c:pt idx="192">
                  <c:v>4</c:v>
                </c:pt>
                <c:pt idx="193">
                  <c:v>4</c:v>
                </c:pt>
                <c:pt idx="194">
                  <c:v>3</c:v>
                </c:pt>
                <c:pt idx="195">
                  <c:v>4</c:v>
                </c:pt>
                <c:pt idx="196">
                  <c:v>6</c:v>
                </c:pt>
                <c:pt idx="197">
                  <c:v>5</c:v>
                </c:pt>
                <c:pt idx="198">
                  <c:v>10</c:v>
                </c:pt>
                <c:pt idx="199">
                  <c:v>5</c:v>
                </c:pt>
                <c:pt idx="200">
                  <c:v>4</c:v>
                </c:pt>
                <c:pt idx="201">
                  <c:v>13</c:v>
                </c:pt>
                <c:pt idx="202">
                  <c:v>11</c:v>
                </c:pt>
                <c:pt idx="203">
                  <c:v>7</c:v>
                </c:pt>
                <c:pt idx="204">
                  <c:v>13</c:v>
                </c:pt>
                <c:pt idx="205">
                  <c:v>17</c:v>
                </c:pt>
                <c:pt idx="206">
                  <c:v>29</c:v>
                </c:pt>
                <c:pt idx="207">
                  <c:v>66</c:v>
                </c:pt>
                <c:pt idx="208">
                  <c:v>120</c:v>
                </c:pt>
                <c:pt idx="209">
                  <c:v>178</c:v>
                </c:pt>
                <c:pt idx="210">
                  <c:v>284</c:v>
                </c:pt>
                <c:pt idx="211">
                  <c:v>510</c:v>
                </c:pt>
                <c:pt idx="212">
                  <c:v>978</c:v>
                </c:pt>
                <c:pt idx="213">
                  <c:v>1665</c:v>
                </c:pt>
                <c:pt idx="214">
                  <c:v>2472</c:v>
                </c:pt>
                <c:pt idx="215">
                  <c:v>2343</c:v>
                </c:pt>
                <c:pt idx="216">
                  <c:v>2072</c:v>
                </c:pt>
                <c:pt idx="217">
                  <c:v>2021</c:v>
                </c:pt>
                <c:pt idx="218">
                  <c:v>1460</c:v>
                </c:pt>
                <c:pt idx="219">
                  <c:v>1043</c:v>
                </c:pt>
                <c:pt idx="220">
                  <c:v>813</c:v>
                </c:pt>
                <c:pt idx="221">
                  <c:v>755</c:v>
                </c:pt>
                <c:pt idx="222">
                  <c:v>449</c:v>
                </c:pt>
                <c:pt idx="223">
                  <c:v>188</c:v>
                </c:pt>
                <c:pt idx="224">
                  <c:v>154</c:v>
                </c:pt>
                <c:pt idx="225">
                  <c:v>86</c:v>
                </c:pt>
                <c:pt idx="226">
                  <c:v>43</c:v>
                </c:pt>
                <c:pt idx="227">
                  <c:v>22</c:v>
                </c:pt>
                <c:pt idx="228">
                  <c:v>18</c:v>
                </c:pt>
                <c:pt idx="229">
                  <c:v>9</c:v>
                </c:pt>
                <c:pt idx="230">
                  <c:v>5</c:v>
                </c:pt>
                <c:pt idx="231">
                  <c:v>5</c:v>
                </c:pt>
                <c:pt idx="232">
                  <c:v>3</c:v>
                </c:pt>
                <c:pt idx="233">
                  <c:v>2</c:v>
                </c:pt>
                <c:pt idx="234">
                  <c:v>3</c:v>
                </c:pt>
                <c:pt idx="235">
                  <c:v>3</c:v>
                </c:pt>
                <c:pt idx="236">
                  <c:v>4</c:v>
                </c:pt>
                <c:pt idx="237">
                  <c:v>5</c:v>
                </c:pt>
                <c:pt idx="238">
                  <c:v>5</c:v>
                </c:pt>
                <c:pt idx="239">
                  <c:v>3</c:v>
                </c:pt>
                <c:pt idx="240">
                  <c:v>11</c:v>
                </c:pt>
                <c:pt idx="241">
                  <c:v>3</c:v>
                </c:pt>
                <c:pt idx="242">
                  <c:v>2</c:v>
                </c:pt>
                <c:pt idx="243">
                  <c:v>6</c:v>
                </c:pt>
                <c:pt idx="244">
                  <c:v>1</c:v>
                </c:pt>
                <c:pt idx="245">
                  <c:v>1</c:v>
                </c:pt>
                <c:pt idx="246">
                  <c:v>7</c:v>
                </c:pt>
                <c:pt idx="247">
                  <c:v>8</c:v>
                </c:pt>
                <c:pt idx="248">
                  <c:v>15</c:v>
                </c:pt>
                <c:pt idx="249">
                  <c:v>17</c:v>
                </c:pt>
                <c:pt idx="250">
                  <c:v>16</c:v>
                </c:pt>
                <c:pt idx="251">
                  <c:v>25</c:v>
                </c:pt>
                <c:pt idx="252">
                  <c:v>38</c:v>
                </c:pt>
                <c:pt idx="253">
                  <c:v>52</c:v>
                </c:pt>
                <c:pt idx="254">
                  <c:v>79</c:v>
                </c:pt>
                <c:pt idx="255">
                  <c:v>93</c:v>
                </c:pt>
                <c:pt idx="256">
                  <c:v>122</c:v>
                </c:pt>
                <c:pt idx="257">
                  <c:v>170</c:v>
                </c:pt>
                <c:pt idx="258">
                  <c:v>203</c:v>
                </c:pt>
                <c:pt idx="259">
                  <c:v>422</c:v>
                </c:pt>
                <c:pt idx="260">
                  <c:v>740</c:v>
                </c:pt>
                <c:pt idx="261">
                  <c:v>1076</c:v>
                </c:pt>
                <c:pt idx="262">
                  <c:v>1308</c:v>
                </c:pt>
                <c:pt idx="263">
                  <c:v>1701</c:v>
                </c:pt>
                <c:pt idx="264">
                  <c:v>2393</c:v>
                </c:pt>
                <c:pt idx="265">
                  <c:v>2562</c:v>
                </c:pt>
                <c:pt idx="266">
                  <c:v>1786</c:v>
                </c:pt>
                <c:pt idx="267">
                  <c:v>1451</c:v>
                </c:pt>
                <c:pt idx="268">
                  <c:v>906</c:v>
                </c:pt>
                <c:pt idx="269">
                  <c:v>608</c:v>
                </c:pt>
                <c:pt idx="270">
                  <c:v>525</c:v>
                </c:pt>
                <c:pt idx="271">
                  <c:v>379</c:v>
                </c:pt>
                <c:pt idx="272">
                  <c:v>295</c:v>
                </c:pt>
                <c:pt idx="273">
                  <c:v>239</c:v>
                </c:pt>
                <c:pt idx="274">
                  <c:v>218</c:v>
                </c:pt>
                <c:pt idx="275">
                  <c:v>157</c:v>
                </c:pt>
                <c:pt idx="276">
                  <c:v>97</c:v>
                </c:pt>
                <c:pt idx="277">
                  <c:v>98</c:v>
                </c:pt>
                <c:pt idx="278">
                  <c:v>51</c:v>
                </c:pt>
                <c:pt idx="279">
                  <c:v>52</c:v>
                </c:pt>
                <c:pt idx="280">
                  <c:v>34</c:v>
                </c:pt>
                <c:pt idx="281">
                  <c:v>30</c:v>
                </c:pt>
                <c:pt idx="282">
                  <c:v>16</c:v>
                </c:pt>
                <c:pt idx="283">
                  <c:v>16</c:v>
                </c:pt>
                <c:pt idx="284">
                  <c:v>8</c:v>
                </c:pt>
                <c:pt idx="285">
                  <c:v>6</c:v>
                </c:pt>
                <c:pt idx="286">
                  <c:v>5</c:v>
                </c:pt>
                <c:pt idx="287">
                  <c:v>7</c:v>
                </c:pt>
                <c:pt idx="288">
                  <c:v>11</c:v>
                </c:pt>
                <c:pt idx="289">
                  <c:v>12</c:v>
                </c:pt>
                <c:pt idx="290">
                  <c:v>9</c:v>
                </c:pt>
                <c:pt idx="291">
                  <c:v>7</c:v>
                </c:pt>
                <c:pt idx="292">
                  <c:v>8</c:v>
                </c:pt>
                <c:pt idx="293">
                  <c:v>9</c:v>
                </c:pt>
                <c:pt idx="294">
                  <c:v>13</c:v>
                </c:pt>
                <c:pt idx="295">
                  <c:v>14</c:v>
                </c:pt>
                <c:pt idx="296">
                  <c:v>7</c:v>
                </c:pt>
                <c:pt idx="297">
                  <c:v>15</c:v>
                </c:pt>
                <c:pt idx="298">
                  <c:v>6</c:v>
                </c:pt>
                <c:pt idx="299">
                  <c:v>12</c:v>
                </c:pt>
                <c:pt idx="300">
                  <c:v>19</c:v>
                </c:pt>
                <c:pt idx="301">
                  <c:v>13</c:v>
                </c:pt>
                <c:pt idx="302">
                  <c:v>14</c:v>
                </c:pt>
                <c:pt idx="303">
                  <c:v>15</c:v>
                </c:pt>
                <c:pt idx="304">
                  <c:v>19</c:v>
                </c:pt>
                <c:pt idx="305">
                  <c:v>29</c:v>
                </c:pt>
                <c:pt idx="306">
                  <c:v>23</c:v>
                </c:pt>
                <c:pt idx="307">
                  <c:v>34</c:v>
                </c:pt>
                <c:pt idx="308">
                  <c:v>78</c:v>
                </c:pt>
                <c:pt idx="309">
                  <c:v>106</c:v>
                </c:pt>
                <c:pt idx="310">
                  <c:v>226</c:v>
                </c:pt>
                <c:pt idx="311">
                  <c:v>460</c:v>
                </c:pt>
                <c:pt idx="312">
                  <c:v>7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B3D-4EC0-A8D6-5E64F831BF1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The predict number of influenza patients calculated from regression mode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E$2:$E$314</c:f>
              <c:numCache>
                <c:formatCode>General</c:formatCode>
                <c:ptCount val="313"/>
                <c:pt idx="0">
                  <c:v>222.70897253049429</c:v>
                </c:pt>
                <c:pt idx="1">
                  <c:v>853.60825604179036</c:v>
                </c:pt>
                <c:pt idx="2">
                  <c:v>1215.7257767049678</c:v>
                </c:pt>
                <c:pt idx="3">
                  <c:v>1701.6932439161301</c:v>
                </c:pt>
                <c:pt idx="4">
                  <c:v>2042.6327475042681</c:v>
                </c:pt>
                <c:pt idx="5">
                  <c:v>1596.7732722093331</c:v>
                </c:pt>
                <c:pt idx="6">
                  <c:v>1294.3305732075778</c:v>
                </c:pt>
                <c:pt idx="7">
                  <c:v>1086.6631199370631</c:v>
                </c:pt>
                <c:pt idx="8">
                  <c:v>893.4063454588736</c:v>
                </c:pt>
                <c:pt idx="9">
                  <c:v>619.15500404176942</c:v>
                </c:pt>
                <c:pt idx="10">
                  <c:v>554.10568778347579</c:v>
                </c:pt>
                <c:pt idx="11">
                  <c:v>620.61232434195063</c:v>
                </c:pt>
                <c:pt idx="12">
                  <c:v>416.40211680267521</c:v>
                </c:pt>
                <c:pt idx="13">
                  <c:v>355.93145417789503</c:v>
                </c:pt>
                <c:pt idx="14">
                  <c:v>275.1992385548474</c:v>
                </c:pt>
                <c:pt idx="15">
                  <c:v>245.91762938208171</c:v>
                </c:pt>
                <c:pt idx="16">
                  <c:v>183.14895463164294</c:v>
                </c:pt>
                <c:pt idx="17">
                  <c:v>49.642069619444726</c:v>
                </c:pt>
                <c:pt idx="18">
                  <c:v>-63.040999999999997</c:v>
                </c:pt>
                <c:pt idx="19">
                  <c:v>85.597505403013656</c:v>
                </c:pt>
                <c:pt idx="20">
                  <c:v>68.378630289576734</c:v>
                </c:pt>
                <c:pt idx="21">
                  <c:v>-142.527240781974</c:v>
                </c:pt>
                <c:pt idx="22">
                  <c:v>-63.120203497504008</c:v>
                </c:pt>
                <c:pt idx="23">
                  <c:v>-117.31944114497168</c:v>
                </c:pt>
                <c:pt idx="24">
                  <c:v>15.061700816630719</c:v>
                </c:pt>
                <c:pt idx="25">
                  <c:v>-65.066620391044182</c:v>
                </c:pt>
                <c:pt idx="26">
                  <c:v>-67.176745277607324</c:v>
                </c:pt>
                <c:pt idx="27">
                  <c:v>-35.746561989648683</c:v>
                </c:pt>
                <c:pt idx="28">
                  <c:v>78.262823888204935</c:v>
                </c:pt>
                <c:pt idx="29">
                  <c:v>-5.20092543117471</c:v>
                </c:pt>
                <c:pt idx="30">
                  <c:v>-80.110646457350299</c:v>
                </c:pt>
                <c:pt idx="31">
                  <c:v>-254.63771789189892</c:v>
                </c:pt>
                <c:pt idx="32">
                  <c:v>24.733106903914859</c:v>
                </c:pt>
                <c:pt idx="33">
                  <c:v>-30.916082652826958</c:v>
                </c:pt>
                <c:pt idx="34">
                  <c:v>78.590108718903821</c:v>
                </c:pt>
                <c:pt idx="35">
                  <c:v>-112.21464464236129</c:v>
                </c:pt>
                <c:pt idx="36">
                  <c:v>-42.300694959983957</c:v>
                </c:pt>
                <c:pt idx="37">
                  <c:v>-118.6516747505533</c:v>
                </c:pt>
                <c:pt idx="38">
                  <c:v>-248.58908356032128</c:v>
                </c:pt>
                <c:pt idx="39">
                  <c:v>17.841621298309917</c:v>
                </c:pt>
                <c:pt idx="40">
                  <c:v>-89.610057494015223</c:v>
                </c:pt>
                <c:pt idx="41">
                  <c:v>37.051659490274631</c:v>
                </c:pt>
                <c:pt idx="42">
                  <c:v>-31.305198548122803</c:v>
                </c:pt>
                <c:pt idx="43">
                  <c:v>21.784909263401005</c:v>
                </c:pt>
                <c:pt idx="44">
                  <c:v>-93.156832879700232</c:v>
                </c:pt>
                <c:pt idx="45">
                  <c:v>39.004059308775709</c:v>
                </c:pt>
                <c:pt idx="46">
                  <c:v>10.856375567069904</c:v>
                </c:pt>
                <c:pt idx="47">
                  <c:v>-55.716123979182953</c:v>
                </c:pt>
                <c:pt idx="48">
                  <c:v>19.816067392548007</c:v>
                </c:pt>
                <c:pt idx="49">
                  <c:v>81.647646457121482</c:v>
                </c:pt>
                <c:pt idx="50">
                  <c:v>170.96020440476923</c:v>
                </c:pt>
                <c:pt idx="51">
                  <c:v>263.47226412556597</c:v>
                </c:pt>
                <c:pt idx="52">
                  <c:v>297.34097253049424</c:v>
                </c:pt>
                <c:pt idx="53">
                  <c:v>788.30525604179047</c:v>
                </c:pt>
                <c:pt idx="54">
                  <c:v>1234.3837767049677</c:v>
                </c:pt>
                <c:pt idx="55">
                  <c:v>1739.0092439161303</c:v>
                </c:pt>
                <c:pt idx="56">
                  <c:v>1874.7107475042681</c:v>
                </c:pt>
                <c:pt idx="57">
                  <c:v>1671.4052722093329</c:v>
                </c:pt>
                <c:pt idx="58">
                  <c:v>1340.9755732075778</c:v>
                </c:pt>
                <c:pt idx="59">
                  <c:v>862.76711993706317</c:v>
                </c:pt>
                <c:pt idx="60">
                  <c:v>734.81334545887353</c:v>
                </c:pt>
                <c:pt idx="61">
                  <c:v>703.11600404176943</c:v>
                </c:pt>
                <c:pt idx="62">
                  <c:v>395.51268778347583</c:v>
                </c:pt>
                <c:pt idx="63">
                  <c:v>247.45232434195054</c:v>
                </c:pt>
                <c:pt idx="64">
                  <c:v>304.45411680267512</c:v>
                </c:pt>
                <c:pt idx="65">
                  <c:v>290.62845417789504</c:v>
                </c:pt>
                <c:pt idx="66">
                  <c:v>32.645238554847424</c:v>
                </c:pt>
                <c:pt idx="67">
                  <c:v>77.995629382081688</c:v>
                </c:pt>
                <c:pt idx="68">
                  <c:v>89.858954631642973</c:v>
                </c:pt>
                <c:pt idx="69">
                  <c:v>77.629069619444635</c:v>
                </c:pt>
                <c:pt idx="70">
                  <c:v>11.591000000000008</c:v>
                </c:pt>
                <c:pt idx="71">
                  <c:v>20.294505403013602</c:v>
                </c:pt>
                <c:pt idx="72">
                  <c:v>31.062630289576703</c:v>
                </c:pt>
                <c:pt idx="73">
                  <c:v>6.736759218026009</c:v>
                </c:pt>
                <c:pt idx="74">
                  <c:v>11.511796502496054</c:v>
                </c:pt>
                <c:pt idx="75">
                  <c:v>87.918558855028323</c:v>
                </c:pt>
                <c:pt idx="76">
                  <c:v>-40.912299183369271</c:v>
                </c:pt>
                <c:pt idx="77">
                  <c:v>-46.408620391044167</c:v>
                </c:pt>
                <c:pt idx="78">
                  <c:v>91.416254722392637</c:v>
                </c:pt>
                <c:pt idx="79">
                  <c:v>48.21443801035133</c:v>
                </c:pt>
                <c:pt idx="80">
                  <c:v>180.88182388820485</c:v>
                </c:pt>
                <c:pt idx="81">
                  <c:v>-14.529925431174661</c:v>
                </c:pt>
                <c:pt idx="82">
                  <c:v>134.45635354264971</c:v>
                </c:pt>
                <c:pt idx="83">
                  <c:v>-2.7547178918988493</c:v>
                </c:pt>
                <c:pt idx="84">
                  <c:v>285.94510690391496</c:v>
                </c:pt>
                <c:pt idx="85">
                  <c:v>-49.574082652826974</c:v>
                </c:pt>
                <c:pt idx="86">
                  <c:v>-145.30589128109625</c:v>
                </c:pt>
                <c:pt idx="87">
                  <c:v>-205.50464464236128</c:v>
                </c:pt>
                <c:pt idx="88">
                  <c:v>4.3443050400160246</c:v>
                </c:pt>
                <c:pt idx="89">
                  <c:v>11.954325249446697</c:v>
                </c:pt>
                <c:pt idx="90">
                  <c:v>-6.0350835603212545</c:v>
                </c:pt>
                <c:pt idx="91">
                  <c:v>27.170621298309925</c:v>
                </c:pt>
                <c:pt idx="92">
                  <c:v>-108.26805749401524</c:v>
                </c:pt>
                <c:pt idx="93">
                  <c:v>-28.251340509725367</c:v>
                </c:pt>
                <c:pt idx="94">
                  <c:v>-49.963198548122818</c:v>
                </c:pt>
                <c:pt idx="95">
                  <c:v>3.1269092634009894</c:v>
                </c:pt>
                <c:pt idx="96">
                  <c:v>-46.51183287970025</c:v>
                </c:pt>
                <c:pt idx="97">
                  <c:v>-35.627940691224353</c:v>
                </c:pt>
                <c:pt idx="98">
                  <c:v>-157.06562443293012</c:v>
                </c:pt>
                <c:pt idx="99">
                  <c:v>-18.400123979183036</c:v>
                </c:pt>
                <c:pt idx="100">
                  <c:v>1.1580673925479914</c:v>
                </c:pt>
                <c:pt idx="101">
                  <c:v>-30.30035354287844</c:v>
                </c:pt>
                <c:pt idx="102">
                  <c:v>142.97320440476915</c:v>
                </c:pt>
                <c:pt idx="103">
                  <c:v>226.15626412556594</c:v>
                </c:pt>
                <c:pt idx="104">
                  <c:v>707.81697253049424</c:v>
                </c:pt>
                <c:pt idx="105">
                  <c:v>695.01525604179051</c:v>
                </c:pt>
                <c:pt idx="106">
                  <c:v>1281.0287767049676</c:v>
                </c:pt>
                <c:pt idx="107">
                  <c:v>1832.2992439161303</c:v>
                </c:pt>
                <c:pt idx="108">
                  <c:v>1865.3817475042683</c:v>
                </c:pt>
                <c:pt idx="109">
                  <c:v>1400.8642722093332</c:v>
                </c:pt>
                <c:pt idx="110">
                  <c:v>1434.2655732075777</c:v>
                </c:pt>
                <c:pt idx="111">
                  <c:v>1030.6891199370632</c:v>
                </c:pt>
                <c:pt idx="112">
                  <c:v>893.4063454588736</c:v>
                </c:pt>
                <c:pt idx="113">
                  <c:v>675.12900404176935</c:v>
                </c:pt>
                <c:pt idx="114">
                  <c:v>302.22268778347575</c:v>
                </c:pt>
                <c:pt idx="115">
                  <c:v>434.03232434195058</c:v>
                </c:pt>
                <c:pt idx="116">
                  <c:v>397.74411680267508</c:v>
                </c:pt>
                <c:pt idx="117">
                  <c:v>234.65445417789499</c:v>
                </c:pt>
                <c:pt idx="118">
                  <c:v>191.2382385548475</c:v>
                </c:pt>
                <c:pt idx="119">
                  <c:v>77.995629382081688</c:v>
                </c:pt>
                <c:pt idx="120">
                  <c:v>33.884954631642984</c:v>
                </c:pt>
                <c:pt idx="121">
                  <c:v>-52.976930380555302</c:v>
                </c:pt>
                <c:pt idx="122">
                  <c:v>86.222999999999956</c:v>
                </c:pt>
                <c:pt idx="123">
                  <c:v>10.965505403013594</c:v>
                </c:pt>
                <c:pt idx="124">
                  <c:v>12.404630289576744</c:v>
                </c:pt>
                <c:pt idx="125">
                  <c:v>90.697759218026022</c:v>
                </c:pt>
                <c:pt idx="126">
                  <c:v>-44.462203497503992</c:v>
                </c:pt>
                <c:pt idx="127">
                  <c:v>-154.63544114497171</c:v>
                </c:pt>
                <c:pt idx="128">
                  <c:v>-143.5312991833693</c:v>
                </c:pt>
                <c:pt idx="129">
                  <c:v>-93.053620391044149</c:v>
                </c:pt>
                <c:pt idx="130">
                  <c:v>-95.163745277607291</c:v>
                </c:pt>
                <c:pt idx="131">
                  <c:v>-110.37856198964869</c:v>
                </c:pt>
                <c:pt idx="132">
                  <c:v>-332.21317611179512</c:v>
                </c:pt>
                <c:pt idx="133">
                  <c:v>-173.12292543117468</c:v>
                </c:pt>
                <c:pt idx="134">
                  <c:v>-126.75564645735028</c:v>
                </c:pt>
                <c:pt idx="135">
                  <c:v>-217.32171789189894</c:v>
                </c:pt>
                <c:pt idx="136">
                  <c:v>-124.53089309608515</c:v>
                </c:pt>
                <c:pt idx="137">
                  <c:v>-49.574082652826974</c:v>
                </c:pt>
                <c:pt idx="138">
                  <c:v>-98.660891281096212</c:v>
                </c:pt>
                <c:pt idx="139">
                  <c:v>93.023355357638707</c:v>
                </c:pt>
                <c:pt idx="140">
                  <c:v>-98.274694959984004</c:v>
                </c:pt>
                <c:pt idx="141">
                  <c:v>-81.335674750553324</c:v>
                </c:pt>
                <c:pt idx="142">
                  <c:v>-108.65408356032128</c:v>
                </c:pt>
                <c:pt idx="143">
                  <c:v>-28.803378701690065</c:v>
                </c:pt>
                <c:pt idx="144">
                  <c:v>-61.623057494015256</c:v>
                </c:pt>
                <c:pt idx="145">
                  <c:v>-18.922340509725359</c:v>
                </c:pt>
                <c:pt idx="146">
                  <c:v>-87.279198548122793</c:v>
                </c:pt>
                <c:pt idx="147">
                  <c:v>96.416909263401067</c:v>
                </c:pt>
                <c:pt idx="148">
                  <c:v>65.436167120299785</c:v>
                </c:pt>
                <c:pt idx="149">
                  <c:v>11.017059308775629</c:v>
                </c:pt>
                <c:pt idx="150">
                  <c:v>-82.433624432930117</c:v>
                </c:pt>
                <c:pt idx="151">
                  <c:v>121.53487602081702</c:v>
                </c:pt>
                <c:pt idx="152">
                  <c:v>94.448067392547955</c:v>
                </c:pt>
                <c:pt idx="153">
                  <c:v>221.58264645712154</c:v>
                </c:pt>
                <c:pt idx="154">
                  <c:v>469.48820440476925</c:v>
                </c:pt>
                <c:pt idx="155">
                  <c:v>1028.4502641255658</c:v>
                </c:pt>
                <c:pt idx="156">
                  <c:v>2844.1579725304946</c:v>
                </c:pt>
                <c:pt idx="157">
                  <c:v>1739.8632560417905</c:v>
                </c:pt>
                <c:pt idx="158">
                  <c:v>1523.5827767049677</c:v>
                </c:pt>
                <c:pt idx="159">
                  <c:v>1711.0222439161303</c:v>
                </c:pt>
                <c:pt idx="160">
                  <c:v>1762.7627475042682</c:v>
                </c:pt>
                <c:pt idx="161">
                  <c:v>1391.535272209333</c:v>
                </c:pt>
                <c:pt idx="162">
                  <c:v>1210.3695732075778</c:v>
                </c:pt>
                <c:pt idx="163">
                  <c:v>769.47711993706321</c:v>
                </c:pt>
                <c:pt idx="164">
                  <c:v>734.81334545887353</c:v>
                </c:pt>
                <c:pt idx="165">
                  <c:v>535.1940040417694</c:v>
                </c:pt>
                <c:pt idx="166">
                  <c:v>442.15768778347581</c:v>
                </c:pt>
                <c:pt idx="167">
                  <c:v>378.05832434195054</c:v>
                </c:pt>
                <c:pt idx="168">
                  <c:v>407.07311680267514</c:v>
                </c:pt>
                <c:pt idx="169">
                  <c:v>178.68045417789506</c:v>
                </c:pt>
                <c:pt idx="170">
                  <c:v>191.2382385548475</c:v>
                </c:pt>
                <c:pt idx="171">
                  <c:v>236.58862938208176</c:v>
                </c:pt>
                <c:pt idx="172">
                  <c:v>80.529954631643022</c:v>
                </c:pt>
                <c:pt idx="173">
                  <c:v>-80.963930380555325</c:v>
                </c:pt>
                <c:pt idx="174">
                  <c:v>384.75099999999998</c:v>
                </c:pt>
                <c:pt idx="175">
                  <c:v>20.294505403013602</c:v>
                </c:pt>
                <c:pt idx="176">
                  <c:v>3.0756302895767362</c:v>
                </c:pt>
                <c:pt idx="177">
                  <c:v>16.065759218026017</c:v>
                </c:pt>
                <c:pt idx="178">
                  <c:v>104.80179650249602</c:v>
                </c:pt>
                <c:pt idx="179">
                  <c:v>78.589558855028372</c:v>
                </c:pt>
                <c:pt idx="180">
                  <c:v>127.0097008166307</c:v>
                </c:pt>
                <c:pt idx="181">
                  <c:v>18.89437960895583</c:v>
                </c:pt>
                <c:pt idx="182">
                  <c:v>44.771254722392712</c:v>
                </c:pt>
                <c:pt idx="183">
                  <c:v>-119.7075619896487</c:v>
                </c:pt>
                <c:pt idx="184">
                  <c:v>-61.672176111795125</c:v>
                </c:pt>
                <c:pt idx="185">
                  <c:v>97.418074568825318</c:v>
                </c:pt>
                <c:pt idx="186">
                  <c:v>181.10135354264969</c:v>
                </c:pt>
                <c:pt idx="187">
                  <c:v>407.72128210810115</c:v>
                </c:pt>
                <c:pt idx="188">
                  <c:v>80.707106903914905</c:v>
                </c:pt>
                <c:pt idx="189">
                  <c:v>15.728917347173024</c:v>
                </c:pt>
                <c:pt idx="190">
                  <c:v>190.5381087189038</c:v>
                </c:pt>
                <c:pt idx="191">
                  <c:v>148.99735535763875</c:v>
                </c:pt>
                <c:pt idx="192">
                  <c:v>-60.958694959983973</c:v>
                </c:pt>
                <c:pt idx="193">
                  <c:v>-146.63867475055332</c:v>
                </c:pt>
                <c:pt idx="194">
                  <c:v>460.41491643967879</c:v>
                </c:pt>
                <c:pt idx="195">
                  <c:v>129.78962129830995</c:v>
                </c:pt>
                <c:pt idx="196">
                  <c:v>59.653942505984787</c:v>
                </c:pt>
                <c:pt idx="197">
                  <c:v>18.393659490274615</c:v>
                </c:pt>
                <c:pt idx="198">
                  <c:v>117.95880145187721</c:v>
                </c:pt>
                <c:pt idx="199">
                  <c:v>-108.82109073659899</c:v>
                </c:pt>
                <c:pt idx="200">
                  <c:v>168.05516712029976</c:v>
                </c:pt>
                <c:pt idx="201">
                  <c:v>-7.640940691224273</c:v>
                </c:pt>
                <c:pt idx="202">
                  <c:v>29.514375567069862</c:v>
                </c:pt>
                <c:pt idx="203">
                  <c:v>261.46987602081697</c:v>
                </c:pt>
                <c:pt idx="204">
                  <c:v>1.1580673925479914</c:v>
                </c:pt>
                <c:pt idx="205">
                  <c:v>35.002646457121557</c:v>
                </c:pt>
                <c:pt idx="206">
                  <c:v>142.97320440476915</c:v>
                </c:pt>
                <c:pt idx="207">
                  <c:v>142.19526412556593</c:v>
                </c:pt>
                <c:pt idx="208">
                  <c:v>120.03186653396358</c:v>
                </c:pt>
                <c:pt idx="209">
                  <c:v>-131.79302746950577</c:v>
                </c:pt>
                <c:pt idx="210">
                  <c:v>1012.2012560417907</c:v>
                </c:pt>
                <c:pt idx="211">
                  <c:v>1141.0937767049677</c:v>
                </c:pt>
                <c:pt idx="212">
                  <c:v>1608.4032439161301</c:v>
                </c:pt>
                <c:pt idx="213">
                  <c:v>1884.0397475042682</c:v>
                </c:pt>
                <c:pt idx="214">
                  <c:v>2147.1842722093334</c:v>
                </c:pt>
                <c:pt idx="215">
                  <c:v>1592.8585732075778</c:v>
                </c:pt>
                <c:pt idx="216">
                  <c:v>1515.7971199370634</c:v>
                </c:pt>
                <c:pt idx="217">
                  <c:v>1285.2243454588736</c:v>
                </c:pt>
                <c:pt idx="218">
                  <c:v>908.35400404176949</c:v>
                </c:pt>
                <c:pt idx="219">
                  <c:v>880.62068778347566</c:v>
                </c:pt>
                <c:pt idx="220">
                  <c:v>629.94132434195058</c:v>
                </c:pt>
                <c:pt idx="221">
                  <c:v>593.65311680267519</c:v>
                </c:pt>
                <c:pt idx="222">
                  <c:v>439.89245417789505</c:v>
                </c:pt>
                <c:pt idx="223">
                  <c:v>321.84423855484749</c:v>
                </c:pt>
                <c:pt idx="224">
                  <c:v>189.94362938208178</c:v>
                </c:pt>
                <c:pt idx="225">
                  <c:v>164.49095463164304</c:v>
                </c:pt>
                <c:pt idx="226">
                  <c:v>180.24806961944478</c:v>
                </c:pt>
                <c:pt idx="227">
                  <c:v>-53.711999999999989</c:v>
                </c:pt>
                <c:pt idx="228">
                  <c:v>29.62350540301361</c:v>
                </c:pt>
                <c:pt idx="229">
                  <c:v>-43.569369710423302</c:v>
                </c:pt>
                <c:pt idx="230">
                  <c:v>-21.250240781973957</c:v>
                </c:pt>
                <c:pt idx="231">
                  <c:v>39.49879650249602</c:v>
                </c:pt>
                <c:pt idx="232">
                  <c:v>59.931558855028356</c:v>
                </c:pt>
                <c:pt idx="233">
                  <c:v>-12.925299183369305</c:v>
                </c:pt>
                <c:pt idx="234">
                  <c:v>205.47437960895581</c:v>
                </c:pt>
                <c:pt idx="235">
                  <c:v>54.100254722392719</c:v>
                </c:pt>
                <c:pt idx="236">
                  <c:v>85.530438010351304</c:v>
                </c:pt>
                <c:pt idx="237">
                  <c:v>-71.001176111795075</c:v>
                </c:pt>
                <c:pt idx="238">
                  <c:v>125.4050745688254</c:v>
                </c:pt>
                <c:pt idx="239">
                  <c:v>-61.452646457350284</c:v>
                </c:pt>
                <c:pt idx="240">
                  <c:v>155.83828210810111</c:v>
                </c:pt>
                <c:pt idx="241">
                  <c:v>-143.18889309608517</c:v>
                </c:pt>
                <c:pt idx="242">
                  <c:v>127.676917347173</c:v>
                </c:pt>
                <c:pt idx="243">
                  <c:v>69.261108718903756</c:v>
                </c:pt>
                <c:pt idx="244">
                  <c:v>121.01035535763867</c:v>
                </c:pt>
                <c:pt idx="245">
                  <c:v>153.60830504001603</c:v>
                </c:pt>
                <c:pt idx="246">
                  <c:v>385.11432524944667</c:v>
                </c:pt>
                <c:pt idx="247">
                  <c:v>115.24191643967879</c:v>
                </c:pt>
                <c:pt idx="248">
                  <c:v>-28.803378701690065</c:v>
                </c:pt>
                <c:pt idx="249">
                  <c:v>171.60194250598477</c:v>
                </c:pt>
                <c:pt idx="250">
                  <c:v>102.35465949027457</c:v>
                </c:pt>
                <c:pt idx="251">
                  <c:v>61.984801451877161</c:v>
                </c:pt>
                <c:pt idx="252">
                  <c:v>105.74590926340102</c:v>
                </c:pt>
                <c:pt idx="253">
                  <c:v>37.449167120299762</c:v>
                </c:pt>
                <c:pt idx="254">
                  <c:v>76.320059308775626</c:v>
                </c:pt>
                <c:pt idx="255">
                  <c:v>188.10737556706988</c:v>
                </c:pt>
                <c:pt idx="256">
                  <c:v>28.24487602081706</c:v>
                </c:pt>
                <c:pt idx="257">
                  <c:v>225.05406739254795</c:v>
                </c:pt>
                <c:pt idx="258">
                  <c:v>380.17564645712162</c:v>
                </c:pt>
                <c:pt idx="259">
                  <c:v>460.15920440476918</c:v>
                </c:pt>
                <c:pt idx="260">
                  <c:v>1037.779264125566</c:v>
                </c:pt>
                <c:pt idx="261">
                  <c:v>997.01597253049431</c:v>
                </c:pt>
                <c:pt idx="262">
                  <c:v>1124.1492560417905</c:v>
                </c:pt>
                <c:pt idx="263">
                  <c:v>1346.3317767049678</c:v>
                </c:pt>
                <c:pt idx="264">
                  <c:v>1673.70624391613</c:v>
                </c:pt>
                <c:pt idx="265">
                  <c:v>2070.6197475042682</c:v>
                </c:pt>
                <c:pt idx="266">
                  <c:v>1699.392272209333</c:v>
                </c:pt>
                <c:pt idx="267">
                  <c:v>1294.3305732075778</c:v>
                </c:pt>
                <c:pt idx="268">
                  <c:v>974.71511993706326</c:v>
                </c:pt>
                <c:pt idx="269">
                  <c:v>837.43234545887344</c:v>
                </c:pt>
                <c:pt idx="270">
                  <c:v>647.1420040417695</c:v>
                </c:pt>
                <c:pt idx="271">
                  <c:v>507.46068778347581</c:v>
                </c:pt>
                <c:pt idx="272">
                  <c:v>490.00632434195052</c:v>
                </c:pt>
                <c:pt idx="273">
                  <c:v>369.75711680267511</c:v>
                </c:pt>
                <c:pt idx="274">
                  <c:v>281.29945417789509</c:v>
                </c:pt>
                <c:pt idx="275">
                  <c:v>209.89623855484751</c:v>
                </c:pt>
                <c:pt idx="276">
                  <c:v>124.64062938208167</c:v>
                </c:pt>
                <c:pt idx="277">
                  <c:v>155.16195463164308</c:v>
                </c:pt>
                <c:pt idx="278">
                  <c:v>273.53806961944474</c:v>
                </c:pt>
                <c:pt idx="279">
                  <c:v>-25.725000000000023</c:v>
                </c:pt>
                <c:pt idx="280">
                  <c:v>48.281505403013625</c:v>
                </c:pt>
                <c:pt idx="281">
                  <c:v>77.707630289576741</c:v>
                </c:pt>
                <c:pt idx="282">
                  <c:v>137.342759218026</c:v>
                </c:pt>
                <c:pt idx="283">
                  <c:v>20.840796502496005</c:v>
                </c:pt>
                <c:pt idx="284">
                  <c:v>78.589558855028372</c:v>
                </c:pt>
                <c:pt idx="285">
                  <c:v>80.364700816630716</c:v>
                </c:pt>
                <c:pt idx="286">
                  <c:v>0.236379608955815</c:v>
                </c:pt>
                <c:pt idx="287">
                  <c:v>-1.8737452776073269</c:v>
                </c:pt>
                <c:pt idx="288">
                  <c:v>160.16243801035125</c:v>
                </c:pt>
                <c:pt idx="289">
                  <c:v>236.8558238882049</c:v>
                </c:pt>
                <c:pt idx="290">
                  <c:v>4.1280745688253546</c:v>
                </c:pt>
                <c:pt idx="291">
                  <c:v>-24.136646457350253</c:v>
                </c:pt>
                <c:pt idx="292">
                  <c:v>-58.728717891898896</c:v>
                </c:pt>
                <c:pt idx="293">
                  <c:v>-96.543893096085071</c:v>
                </c:pt>
                <c:pt idx="294">
                  <c:v>15.728917347173024</c:v>
                </c:pt>
                <c:pt idx="295">
                  <c:v>-61.344891281096238</c:v>
                </c:pt>
                <c:pt idx="296">
                  <c:v>-28.25364464236128</c:v>
                </c:pt>
                <c:pt idx="297">
                  <c:v>69.647305040016022</c:v>
                </c:pt>
                <c:pt idx="298">
                  <c:v>-25.361674750553334</c:v>
                </c:pt>
                <c:pt idx="299">
                  <c:v>-183.28608356032123</c:v>
                </c:pt>
                <c:pt idx="300">
                  <c:v>-66.119378701690096</c:v>
                </c:pt>
                <c:pt idx="301">
                  <c:v>78.311942505984803</c:v>
                </c:pt>
                <c:pt idx="302">
                  <c:v>-65.567340509725398</c:v>
                </c:pt>
                <c:pt idx="303">
                  <c:v>52.65580145187721</c:v>
                </c:pt>
                <c:pt idx="304">
                  <c:v>-34.189090736598985</c:v>
                </c:pt>
                <c:pt idx="305">
                  <c:v>-9.1958328797002196</c:v>
                </c:pt>
                <c:pt idx="306">
                  <c:v>66.991059308775675</c:v>
                </c:pt>
                <c:pt idx="307">
                  <c:v>216.09437556706985</c:v>
                </c:pt>
                <c:pt idx="308">
                  <c:v>-9.0711239791829712</c:v>
                </c:pt>
                <c:pt idx="309">
                  <c:v>122.43506739254792</c:v>
                </c:pt>
                <c:pt idx="310">
                  <c:v>118.96364645712151</c:v>
                </c:pt>
                <c:pt idx="311">
                  <c:v>385.52720440476924</c:v>
                </c:pt>
                <c:pt idx="312">
                  <c:v>1075.09526412556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B3D-4EC0-A8D6-5E64F831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7113808"/>
        <c:axId val="1626116352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発熱トリアージ件数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86</c:v>
                      </c:pt>
                      <c:pt idx="1">
                        <c:v>67</c:v>
                      </c:pt>
                      <c:pt idx="2">
                        <c:v>81</c:v>
                      </c:pt>
                      <c:pt idx="3">
                        <c:v>80</c:v>
                      </c:pt>
                      <c:pt idx="4">
                        <c:v>103</c:v>
                      </c:pt>
                      <c:pt idx="5">
                        <c:v>88</c:v>
                      </c:pt>
                      <c:pt idx="6">
                        <c:v>72</c:v>
                      </c:pt>
                      <c:pt idx="7">
                        <c:v>71</c:v>
                      </c:pt>
                      <c:pt idx="8">
                        <c:v>58</c:v>
                      </c:pt>
                      <c:pt idx="9">
                        <c:v>48</c:v>
                      </c:pt>
                      <c:pt idx="10">
                        <c:v>53</c:v>
                      </c:pt>
                      <c:pt idx="11">
                        <c:v>79</c:v>
                      </c:pt>
                      <c:pt idx="12">
                        <c:v>51</c:v>
                      </c:pt>
                      <c:pt idx="13">
                        <c:v>59</c:v>
                      </c:pt>
                      <c:pt idx="14">
                        <c:v>45</c:v>
                      </c:pt>
                      <c:pt idx="15">
                        <c:v>59</c:v>
                      </c:pt>
                      <c:pt idx="16">
                        <c:v>53</c:v>
                      </c:pt>
                      <c:pt idx="17">
                        <c:v>68</c:v>
                      </c:pt>
                      <c:pt idx="18">
                        <c:v>40</c:v>
                      </c:pt>
                      <c:pt idx="19">
                        <c:v>40</c:v>
                      </c:pt>
                      <c:pt idx="20">
                        <c:v>41</c:v>
                      </c:pt>
                      <c:pt idx="21">
                        <c:v>23</c:v>
                      </c:pt>
                      <c:pt idx="22">
                        <c:v>35</c:v>
                      </c:pt>
                      <c:pt idx="23">
                        <c:v>32</c:v>
                      </c:pt>
                      <c:pt idx="24">
                        <c:v>42</c:v>
                      </c:pt>
                      <c:pt idx="25">
                        <c:v>39</c:v>
                      </c:pt>
                      <c:pt idx="26">
                        <c:v>37</c:v>
                      </c:pt>
                      <c:pt idx="27">
                        <c:v>41</c:v>
                      </c:pt>
                      <c:pt idx="28">
                        <c:v>77</c:v>
                      </c:pt>
                      <c:pt idx="29">
                        <c:v>58</c:v>
                      </c:pt>
                      <c:pt idx="30">
                        <c:v>53</c:v>
                      </c:pt>
                      <c:pt idx="31">
                        <c:v>43</c:v>
                      </c:pt>
                      <c:pt idx="32">
                        <c:v>76</c:v>
                      </c:pt>
                      <c:pt idx="33">
                        <c:v>39</c:v>
                      </c:pt>
                      <c:pt idx="34">
                        <c:v>55</c:v>
                      </c:pt>
                      <c:pt idx="35">
                        <c:v>23</c:v>
                      </c:pt>
                      <c:pt idx="36">
                        <c:v>35</c:v>
                      </c:pt>
                      <c:pt idx="37">
                        <c:v>36</c:v>
                      </c:pt>
                      <c:pt idx="38">
                        <c:v>29</c:v>
                      </c:pt>
                      <c:pt idx="39">
                        <c:v>47</c:v>
                      </c:pt>
                      <c:pt idx="40">
                        <c:v>30</c:v>
                      </c:pt>
                      <c:pt idx="41">
                        <c:v>39</c:v>
                      </c:pt>
                      <c:pt idx="42">
                        <c:v>27</c:v>
                      </c:pt>
                      <c:pt idx="43">
                        <c:v>40</c:v>
                      </c:pt>
                      <c:pt idx="44">
                        <c:v>34</c:v>
                      </c:pt>
                      <c:pt idx="45">
                        <c:v>40</c:v>
                      </c:pt>
                      <c:pt idx="46">
                        <c:v>42</c:v>
                      </c:pt>
                      <c:pt idx="47">
                        <c:v>26</c:v>
                      </c:pt>
                      <c:pt idx="48">
                        <c:v>36</c:v>
                      </c:pt>
                      <c:pt idx="49">
                        <c:v>38</c:v>
                      </c:pt>
                      <c:pt idx="50">
                        <c:v>36</c:v>
                      </c:pt>
                      <c:pt idx="51">
                        <c:v>51</c:v>
                      </c:pt>
                      <c:pt idx="52">
                        <c:v>94</c:v>
                      </c:pt>
                      <c:pt idx="53">
                        <c:v>60</c:v>
                      </c:pt>
                      <c:pt idx="54">
                        <c:v>83</c:v>
                      </c:pt>
                      <c:pt idx="55">
                        <c:v>84</c:v>
                      </c:pt>
                      <c:pt idx="56">
                        <c:v>85</c:v>
                      </c:pt>
                      <c:pt idx="57">
                        <c:v>96</c:v>
                      </c:pt>
                      <c:pt idx="58">
                        <c:v>77</c:v>
                      </c:pt>
                      <c:pt idx="59">
                        <c:v>47</c:v>
                      </c:pt>
                      <c:pt idx="60">
                        <c:v>41</c:v>
                      </c:pt>
                      <c:pt idx="61">
                        <c:v>57</c:v>
                      </c:pt>
                      <c:pt idx="62">
                        <c:v>36</c:v>
                      </c:pt>
                      <c:pt idx="63">
                        <c:v>39</c:v>
                      </c:pt>
                      <c:pt idx="64">
                        <c:v>39</c:v>
                      </c:pt>
                      <c:pt idx="65">
                        <c:v>52</c:v>
                      </c:pt>
                      <c:pt idx="66">
                        <c:v>19</c:v>
                      </c:pt>
                      <c:pt idx="67">
                        <c:v>41</c:v>
                      </c:pt>
                      <c:pt idx="68">
                        <c:v>43</c:v>
                      </c:pt>
                      <c:pt idx="69">
                        <c:v>71</c:v>
                      </c:pt>
                      <c:pt idx="70">
                        <c:v>48</c:v>
                      </c:pt>
                      <c:pt idx="71">
                        <c:v>33</c:v>
                      </c:pt>
                      <c:pt idx="72">
                        <c:v>37</c:v>
                      </c:pt>
                      <c:pt idx="73">
                        <c:v>39</c:v>
                      </c:pt>
                      <c:pt idx="74">
                        <c:v>43</c:v>
                      </c:pt>
                      <c:pt idx="75">
                        <c:v>54</c:v>
                      </c:pt>
                      <c:pt idx="76">
                        <c:v>36</c:v>
                      </c:pt>
                      <c:pt idx="77">
                        <c:v>41</c:v>
                      </c:pt>
                      <c:pt idx="78">
                        <c:v>54</c:v>
                      </c:pt>
                      <c:pt idx="79">
                        <c:v>50</c:v>
                      </c:pt>
                      <c:pt idx="80">
                        <c:v>88</c:v>
                      </c:pt>
                      <c:pt idx="81">
                        <c:v>57</c:v>
                      </c:pt>
                      <c:pt idx="82">
                        <c:v>76</c:v>
                      </c:pt>
                      <c:pt idx="83">
                        <c:v>70</c:v>
                      </c:pt>
                      <c:pt idx="84">
                        <c:v>104</c:v>
                      </c:pt>
                      <c:pt idx="85">
                        <c:v>37</c:v>
                      </c:pt>
                      <c:pt idx="86">
                        <c:v>31</c:v>
                      </c:pt>
                      <c:pt idx="87">
                        <c:v>13</c:v>
                      </c:pt>
                      <c:pt idx="88">
                        <c:v>40</c:v>
                      </c:pt>
                      <c:pt idx="89">
                        <c:v>50</c:v>
                      </c:pt>
                      <c:pt idx="90">
                        <c:v>55</c:v>
                      </c:pt>
                      <c:pt idx="91">
                        <c:v>48</c:v>
                      </c:pt>
                      <c:pt idx="92">
                        <c:v>28</c:v>
                      </c:pt>
                      <c:pt idx="93">
                        <c:v>32</c:v>
                      </c:pt>
                      <c:pt idx="94">
                        <c:v>25</c:v>
                      </c:pt>
                      <c:pt idx="95">
                        <c:v>38</c:v>
                      </c:pt>
                      <c:pt idx="96">
                        <c:v>39</c:v>
                      </c:pt>
                      <c:pt idx="97">
                        <c:v>32</c:v>
                      </c:pt>
                      <c:pt idx="98">
                        <c:v>24</c:v>
                      </c:pt>
                      <c:pt idx="99">
                        <c:v>30</c:v>
                      </c:pt>
                      <c:pt idx="100">
                        <c:v>34</c:v>
                      </c:pt>
                      <c:pt idx="101">
                        <c:v>26</c:v>
                      </c:pt>
                      <c:pt idx="102">
                        <c:v>33</c:v>
                      </c:pt>
                      <c:pt idx="103">
                        <c:v>47</c:v>
                      </c:pt>
                      <c:pt idx="104">
                        <c:v>138</c:v>
                      </c:pt>
                      <c:pt idx="105">
                        <c:v>50</c:v>
                      </c:pt>
                      <c:pt idx="106">
                        <c:v>88</c:v>
                      </c:pt>
                      <c:pt idx="107">
                        <c:v>94</c:v>
                      </c:pt>
                      <c:pt idx="108">
                        <c:v>84</c:v>
                      </c:pt>
                      <c:pt idx="109">
                        <c:v>67</c:v>
                      </c:pt>
                      <c:pt idx="110">
                        <c:v>87</c:v>
                      </c:pt>
                      <c:pt idx="111">
                        <c:v>65</c:v>
                      </c:pt>
                      <c:pt idx="112">
                        <c:v>58</c:v>
                      </c:pt>
                      <c:pt idx="113">
                        <c:v>54</c:v>
                      </c:pt>
                      <c:pt idx="114">
                        <c:v>26</c:v>
                      </c:pt>
                      <c:pt idx="115">
                        <c:v>59</c:v>
                      </c:pt>
                      <c:pt idx="116">
                        <c:v>49</c:v>
                      </c:pt>
                      <c:pt idx="117">
                        <c:v>46</c:v>
                      </c:pt>
                      <c:pt idx="118">
                        <c:v>36</c:v>
                      </c:pt>
                      <c:pt idx="119">
                        <c:v>41</c:v>
                      </c:pt>
                      <c:pt idx="120">
                        <c:v>37</c:v>
                      </c:pt>
                      <c:pt idx="121">
                        <c:v>57</c:v>
                      </c:pt>
                      <c:pt idx="122">
                        <c:v>56</c:v>
                      </c:pt>
                      <c:pt idx="123">
                        <c:v>32</c:v>
                      </c:pt>
                      <c:pt idx="124">
                        <c:v>35</c:v>
                      </c:pt>
                      <c:pt idx="125">
                        <c:v>48</c:v>
                      </c:pt>
                      <c:pt idx="126">
                        <c:v>37</c:v>
                      </c:pt>
                      <c:pt idx="127">
                        <c:v>28</c:v>
                      </c:pt>
                      <c:pt idx="128">
                        <c:v>25</c:v>
                      </c:pt>
                      <c:pt idx="129">
                        <c:v>36</c:v>
                      </c:pt>
                      <c:pt idx="130">
                        <c:v>34</c:v>
                      </c:pt>
                      <c:pt idx="131">
                        <c:v>33</c:v>
                      </c:pt>
                      <c:pt idx="132">
                        <c:v>33</c:v>
                      </c:pt>
                      <c:pt idx="133">
                        <c:v>40</c:v>
                      </c:pt>
                      <c:pt idx="134">
                        <c:v>48</c:v>
                      </c:pt>
                      <c:pt idx="135">
                        <c:v>47</c:v>
                      </c:pt>
                      <c:pt idx="136">
                        <c:v>60</c:v>
                      </c:pt>
                      <c:pt idx="137">
                        <c:v>37</c:v>
                      </c:pt>
                      <c:pt idx="138">
                        <c:v>36</c:v>
                      </c:pt>
                      <c:pt idx="139">
                        <c:v>45</c:v>
                      </c:pt>
                      <c:pt idx="140">
                        <c:v>29</c:v>
                      </c:pt>
                      <c:pt idx="141">
                        <c:v>40</c:v>
                      </c:pt>
                      <c:pt idx="142">
                        <c:v>44</c:v>
                      </c:pt>
                      <c:pt idx="143">
                        <c:v>42</c:v>
                      </c:pt>
                      <c:pt idx="144">
                        <c:v>33</c:v>
                      </c:pt>
                      <c:pt idx="145">
                        <c:v>33</c:v>
                      </c:pt>
                      <c:pt idx="146">
                        <c:v>21</c:v>
                      </c:pt>
                      <c:pt idx="147">
                        <c:v>48</c:v>
                      </c:pt>
                      <c:pt idx="148">
                        <c:v>51</c:v>
                      </c:pt>
                      <c:pt idx="149">
                        <c:v>37</c:v>
                      </c:pt>
                      <c:pt idx="150">
                        <c:v>32</c:v>
                      </c:pt>
                      <c:pt idx="151">
                        <c:v>45</c:v>
                      </c:pt>
                      <c:pt idx="152">
                        <c:v>44</c:v>
                      </c:pt>
                      <c:pt idx="153">
                        <c:v>53</c:v>
                      </c:pt>
                      <c:pt idx="154">
                        <c:v>68</c:v>
                      </c:pt>
                      <c:pt idx="155">
                        <c:v>133</c:v>
                      </c:pt>
                      <c:pt idx="156">
                        <c:v>367</c:v>
                      </c:pt>
                      <c:pt idx="157">
                        <c:v>162</c:v>
                      </c:pt>
                      <c:pt idx="158">
                        <c:v>114</c:v>
                      </c:pt>
                      <c:pt idx="159">
                        <c:v>81</c:v>
                      </c:pt>
                      <c:pt idx="160">
                        <c:v>73</c:v>
                      </c:pt>
                      <c:pt idx="161">
                        <c:v>66</c:v>
                      </c:pt>
                      <c:pt idx="162">
                        <c:v>63</c:v>
                      </c:pt>
                      <c:pt idx="163">
                        <c:v>37</c:v>
                      </c:pt>
                      <c:pt idx="164">
                        <c:v>41</c:v>
                      </c:pt>
                      <c:pt idx="165">
                        <c:v>39</c:v>
                      </c:pt>
                      <c:pt idx="166">
                        <c:v>41</c:v>
                      </c:pt>
                      <c:pt idx="167">
                        <c:v>53</c:v>
                      </c:pt>
                      <c:pt idx="168">
                        <c:v>50</c:v>
                      </c:pt>
                      <c:pt idx="169">
                        <c:v>40</c:v>
                      </c:pt>
                      <c:pt idx="170">
                        <c:v>36</c:v>
                      </c:pt>
                      <c:pt idx="171">
                        <c:v>58</c:v>
                      </c:pt>
                      <c:pt idx="172">
                        <c:v>42</c:v>
                      </c:pt>
                      <c:pt idx="173">
                        <c:v>54</c:v>
                      </c:pt>
                      <c:pt idx="174">
                        <c:v>88</c:v>
                      </c:pt>
                      <c:pt idx="175">
                        <c:v>33</c:v>
                      </c:pt>
                      <c:pt idx="176">
                        <c:v>34</c:v>
                      </c:pt>
                      <c:pt idx="177">
                        <c:v>40</c:v>
                      </c:pt>
                      <c:pt idx="178">
                        <c:v>53</c:v>
                      </c:pt>
                      <c:pt idx="179">
                        <c:v>53</c:v>
                      </c:pt>
                      <c:pt idx="180">
                        <c:v>54</c:v>
                      </c:pt>
                      <c:pt idx="181">
                        <c:v>48</c:v>
                      </c:pt>
                      <c:pt idx="182">
                        <c:v>49</c:v>
                      </c:pt>
                      <c:pt idx="183">
                        <c:v>32</c:v>
                      </c:pt>
                      <c:pt idx="184">
                        <c:v>62</c:v>
                      </c:pt>
                      <c:pt idx="185">
                        <c:v>69</c:v>
                      </c:pt>
                      <c:pt idx="186">
                        <c:v>81</c:v>
                      </c:pt>
                      <c:pt idx="187">
                        <c:v>114</c:v>
                      </c:pt>
                      <c:pt idx="188">
                        <c:v>82</c:v>
                      </c:pt>
                      <c:pt idx="189">
                        <c:v>44</c:v>
                      </c:pt>
                      <c:pt idx="190">
                        <c:v>67</c:v>
                      </c:pt>
                      <c:pt idx="191">
                        <c:v>51</c:v>
                      </c:pt>
                      <c:pt idx="192">
                        <c:v>33</c:v>
                      </c:pt>
                      <c:pt idx="193">
                        <c:v>33</c:v>
                      </c:pt>
                      <c:pt idx="194">
                        <c:v>105</c:v>
                      </c:pt>
                      <c:pt idx="195">
                        <c:v>59</c:v>
                      </c:pt>
                      <c:pt idx="196">
                        <c:v>46</c:v>
                      </c:pt>
                      <c:pt idx="197">
                        <c:v>37</c:v>
                      </c:pt>
                      <c:pt idx="198">
                        <c:v>43</c:v>
                      </c:pt>
                      <c:pt idx="199">
                        <c:v>26</c:v>
                      </c:pt>
                      <c:pt idx="200">
                        <c:v>62</c:v>
                      </c:pt>
                      <c:pt idx="201">
                        <c:v>35</c:v>
                      </c:pt>
                      <c:pt idx="202">
                        <c:v>44</c:v>
                      </c:pt>
                      <c:pt idx="203">
                        <c:v>60</c:v>
                      </c:pt>
                      <c:pt idx="204">
                        <c:v>34</c:v>
                      </c:pt>
                      <c:pt idx="205">
                        <c:v>33</c:v>
                      </c:pt>
                      <c:pt idx="206">
                        <c:v>33</c:v>
                      </c:pt>
                      <c:pt idx="207">
                        <c:v>38</c:v>
                      </c:pt>
                      <c:pt idx="208">
                        <c:v>116</c:v>
                      </c:pt>
                      <c:pt idx="209">
                        <c:v>48</c:v>
                      </c:pt>
                      <c:pt idx="210">
                        <c:v>84</c:v>
                      </c:pt>
                      <c:pt idx="211">
                        <c:v>73</c:v>
                      </c:pt>
                      <c:pt idx="212">
                        <c:v>70</c:v>
                      </c:pt>
                      <c:pt idx="213">
                        <c:v>86</c:v>
                      </c:pt>
                      <c:pt idx="214">
                        <c:v>147</c:v>
                      </c:pt>
                      <c:pt idx="215">
                        <c:v>104</c:v>
                      </c:pt>
                      <c:pt idx="216">
                        <c:v>117</c:v>
                      </c:pt>
                      <c:pt idx="217">
                        <c:v>100</c:v>
                      </c:pt>
                      <c:pt idx="218">
                        <c:v>79</c:v>
                      </c:pt>
                      <c:pt idx="219">
                        <c:v>88</c:v>
                      </c:pt>
                      <c:pt idx="220">
                        <c:v>80</c:v>
                      </c:pt>
                      <c:pt idx="221">
                        <c:v>70</c:v>
                      </c:pt>
                      <c:pt idx="222">
                        <c:v>68</c:v>
                      </c:pt>
                      <c:pt idx="223">
                        <c:v>50</c:v>
                      </c:pt>
                      <c:pt idx="224">
                        <c:v>53</c:v>
                      </c:pt>
                      <c:pt idx="225">
                        <c:v>51</c:v>
                      </c:pt>
                      <c:pt idx="226">
                        <c:v>82</c:v>
                      </c:pt>
                      <c:pt idx="227">
                        <c:v>41</c:v>
                      </c:pt>
                      <c:pt idx="228">
                        <c:v>34</c:v>
                      </c:pt>
                      <c:pt idx="229">
                        <c:v>29</c:v>
                      </c:pt>
                      <c:pt idx="230">
                        <c:v>36</c:v>
                      </c:pt>
                      <c:pt idx="231">
                        <c:v>46</c:v>
                      </c:pt>
                      <c:pt idx="232">
                        <c:v>51</c:v>
                      </c:pt>
                      <c:pt idx="233">
                        <c:v>39</c:v>
                      </c:pt>
                      <c:pt idx="234">
                        <c:v>68</c:v>
                      </c:pt>
                      <c:pt idx="235">
                        <c:v>50</c:v>
                      </c:pt>
                      <c:pt idx="236">
                        <c:v>54</c:v>
                      </c:pt>
                      <c:pt idx="237">
                        <c:v>61</c:v>
                      </c:pt>
                      <c:pt idx="238">
                        <c:v>72</c:v>
                      </c:pt>
                      <c:pt idx="239">
                        <c:v>55</c:v>
                      </c:pt>
                      <c:pt idx="240">
                        <c:v>87</c:v>
                      </c:pt>
                      <c:pt idx="241">
                        <c:v>58</c:v>
                      </c:pt>
                      <c:pt idx="242">
                        <c:v>56</c:v>
                      </c:pt>
                      <c:pt idx="243">
                        <c:v>54</c:v>
                      </c:pt>
                      <c:pt idx="244">
                        <c:v>48</c:v>
                      </c:pt>
                      <c:pt idx="245">
                        <c:v>56</c:v>
                      </c:pt>
                      <c:pt idx="246">
                        <c:v>90</c:v>
                      </c:pt>
                      <c:pt idx="247">
                        <c:v>68</c:v>
                      </c:pt>
                      <c:pt idx="248">
                        <c:v>42</c:v>
                      </c:pt>
                      <c:pt idx="249">
                        <c:v>58</c:v>
                      </c:pt>
                      <c:pt idx="250">
                        <c:v>46</c:v>
                      </c:pt>
                      <c:pt idx="251">
                        <c:v>37</c:v>
                      </c:pt>
                      <c:pt idx="252">
                        <c:v>49</c:v>
                      </c:pt>
                      <c:pt idx="253">
                        <c:v>48</c:v>
                      </c:pt>
                      <c:pt idx="254">
                        <c:v>44</c:v>
                      </c:pt>
                      <c:pt idx="255">
                        <c:v>61</c:v>
                      </c:pt>
                      <c:pt idx="256">
                        <c:v>35</c:v>
                      </c:pt>
                      <c:pt idx="257">
                        <c:v>58</c:v>
                      </c:pt>
                      <c:pt idx="258">
                        <c:v>70</c:v>
                      </c:pt>
                      <c:pt idx="259">
                        <c:v>67</c:v>
                      </c:pt>
                      <c:pt idx="260">
                        <c:v>134</c:v>
                      </c:pt>
                      <c:pt idx="261">
                        <c:v>169</c:v>
                      </c:pt>
                      <c:pt idx="262">
                        <c:v>96</c:v>
                      </c:pt>
                      <c:pt idx="263">
                        <c:v>95</c:v>
                      </c:pt>
                      <c:pt idx="264">
                        <c:v>77</c:v>
                      </c:pt>
                      <c:pt idx="265">
                        <c:v>106</c:v>
                      </c:pt>
                      <c:pt idx="266">
                        <c:v>99</c:v>
                      </c:pt>
                      <c:pt idx="267">
                        <c:v>72</c:v>
                      </c:pt>
                      <c:pt idx="268">
                        <c:v>59</c:v>
                      </c:pt>
                      <c:pt idx="269">
                        <c:v>52</c:v>
                      </c:pt>
                      <c:pt idx="270">
                        <c:v>51</c:v>
                      </c:pt>
                      <c:pt idx="271">
                        <c:v>48</c:v>
                      </c:pt>
                      <c:pt idx="272">
                        <c:v>65</c:v>
                      </c:pt>
                      <c:pt idx="273">
                        <c:v>46</c:v>
                      </c:pt>
                      <c:pt idx="274">
                        <c:v>51</c:v>
                      </c:pt>
                      <c:pt idx="275">
                        <c:v>38</c:v>
                      </c:pt>
                      <c:pt idx="276">
                        <c:v>46</c:v>
                      </c:pt>
                      <c:pt idx="277">
                        <c:v>50</c:v>
                      </c:pt>
                      <c:pt idx="278">
                        <c:v>92</c:v>
                      </c:pt>
                      <c:pt idx="279">
                        <c:v>44</c:v>
                      </c:pt>
                      <c:pt idx="280">
                        <c:v>36</c:v>
                      </c:pt>
                      <c:pt idx="281">
                        <c:v>42</c:v>
                      </c:pt>
                      <c:pt idx="282">
                        <c:v>53</c:v>
                      </c:pt>
                      <c:pt idx="283">
                        <c:v>44</c:v>
                      </c:pt>
                      <c:pt idx="284">
                        <c:v>53</c:v>
                      </c:pt>
                      <c:pt idx="285">
                        <c:v>49</c:v>
                      </c:pt>
                      <c:pt idx="286">
                        <c:v>46</c:v>
                      </c:pt>
                      <c:pt idx="287">
                        <c:v>44</c:v>
                      </c:pt>
                      <c:pt idx="288">
                        <c:v>62</c:v>
                      </c:pt>
                      <c:pt idx="289">
                        <c:v>94</c:v>
                      </c:pt>
                      <c:pt idx="290">
                        <c:v>59</c:v>
                      </c:pt>
                      <c:pt idx="291">
                        <c:v>59</c:v>
                      </c:pt>
                      <c:pt idx="292">
                        <c:v>64</c:v>
                      </c:pt>
                      <c:pt idx="293">
                        <c:v>63</c:v>
                      </c:pt>
                      <c:pt idx="294">
                        <c:v>44</c:v>
                      </c:pt>
                      <c:pt idx="295">
                        <c:v>40</c:v>
                      </c:pt>
                      <c:pt idx="296">
                        <c:v>32</c:v>
                      </c:pt>
                      <c:pt idx="297">
                        <c:v>47</c:v>
                      </c:pt>
                      <c:pt idx="298">
                        <c:v>46</c:v>
                      </c:pt>
                      <c:pt idx="299">
                        <c:v>36</c:v>
                      </c:pt>
                      <c:pt idx="300">
                        <c:v>38</c:v>
                      </c:pt>
                      <c:pt idx="301">
                        <c:v>48</c:v>
                      </c:pt>
                      <c:pt idx="302">
                        <c:v>28</c:v>
                      </c:pt>
                      <c:pt idx="303">
                        <c:v>36</c:v>
                      </c:pt>
                      <c:pt idx="304">
                        <c:v>34</c:v>
                      </c:pt>
                      <c:pt idx="305">
                        <c:v>43</c:v>
                      </c:pt>
                      <c:pt idx="306">
                        <c:v>43</c:v>
                      </c:pt>
                      <c:pt idx="307">
                        <c:v>64</c:v>
                      </c:pt>
                      <c:pt idx="308">
                        <c:v>31</c:v>
                      </c:pt>
                      <c:pt idx="309">
                        <c:v>47</c:v>
                      </c:pt>
                      <c:pt idx="310">
                        <c:v>42</c:v>
                      </c:pt>
                      <c:pt idx="311">
                        <c:v>59</c:v>
                      </c:pt>
                      <c:pt idx="312">
                        <c:v>138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B3D-4EC0-A8D6-5E64F831BF17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Week係数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-143.38402746950575</c:v>
                      </c:pt>
                      <c:pt idx="1">
                        <c:v>664.76625604179048</c:v>
                      </c:pt>
                      <c:pt idx="2">
                        <c:v>896.27777670496766</c:v>
                      </c:pt>
                      <c:pt idx="3">
                        <c:v>1391.5742439161302</c:v>
                      </c:pt>
                      <c:pt idx="4">
                        <c:v>1517.9467475042682</c:v>
                      </c:pt>
                      <c:pt idx="5">
                        <c:v>1212.0222722093331</c:v>
                      </c:pt>
                      <c:pt idx="6">
                        <c:v>1058.8435732075777</c:v>
                      </c:pt>
                      <c:pt idx="7">
                        <c:v>860.50511993706323</c:v>
                      </c:pt>
                      <c:pt idx="8">
                        <c:v>788.52534545887352</c:v>
                      </c:pt>
                      <c:pt idx="9">
                        <c:v>607.56400404176941</c:v>
                      </c:pt>
                      <c:pt idx="10">
                        <c:v>495.8696877834758</c:v>
                      </c:pt>
                      <c:pt idx="11">
                        <c:v>319.82232434195055</c:v>
                      </c:pt>
                      <c:pt idx="12">
                        <c:v>376.82411680267512</c:v>
                      </c:pt>
                      <c:pt idx="13">
                        <c:v>241.72145417789503</c:v>
                      </c:pt>
                      <c:pt idx="14">
                        <c:v>291.59523855484747</c:v>
                      </c:pt>
                      <c:pt idx="15">
                        <c:v>131.70762938208173</c:v>
                      </c:pt>
                      <c:pt idx="16">
                        <c:v>124.912954631643</c:v>
                      </c:pt>
                      <c:pt idx="17">
                        <c:v>-148.52893038055532</c:v>
                      </c:pt>
                      <c:pt idx="18">
                        <c:v>0</c:v>
                      </c:pt>
                      <c:pt idx="19">
                        <c:v>148.6385054030136</c:v>
                      </c:pt>
                      <c:pt idx="20">
                        <c:v>122.09063028957671</c:v>
                      </c:pt>
                      <c:pt idx="21">
                        <c:v>79.106759218026014</c:v>
                      </c:pt>
                      <c:pt idx="22">
                        <c:v>46.565796502495999</c:v>
                      </c:pt>
                      <c:pt idx="23">
                        <c:v>20.353558855028339</c:v>
                      </c:pt>
                      <c:pt idx="24">
                        <c:v>59.444700816630693</c:v>
                      </c:pt>
                      <c:pt idx="25">
                        <c:v>7.3033796089558116</c:v>
                      </c:pt>
                      <c:pt idx="26">
                        <c:v>23.851254722392689</c:v>
                      </c:pt>
                      <c:pt idx="27">
                        <c:v>17.965438010351281</c:v>
                      </c:pt>
                      <c:pt idx="28">
                        <c:v>-203.86917611179513</c:v>
                      </c:pt>
                      <c:pt idx="29">
                        <c:v>-110.08192543117467</c:v>
                      </c:pt>
                      <c:pt idx="30">
                        <c:v>-138.34664645735029</c:v>
                      </c:pt>
                      <c:pt idx="31">
                        <c:v>-219.58371789189894</c:v>
                      </c:pt>
                      <c:pt idx="32">
                        <c:v>-248.06989309608511</c:v>
                      </c:pt>
                      <c:pt idx="33">
                        <c:v>41.453917347173018</c:v>
                      </c:pt>
                      <c:pt idx="34">
                        <c:v>1.696108718903778</c:v>
                      </c:pt>
                      <c:pt idx="35">
                        <c:v>109.41935535763872</c:v>
                      </c:pt>
                      <c:pt idx="36">
                        <c:v>67.38530504001605</c:v>
                      </c:pt>
                      <c:pt idx="37">
                        <c:v>-18.29467475055332</c:v>
                      </c:pt>
                      <c:pt idx="38">
                        <c:v>-82.929083560321274</c:v>
                      </c:pt>
                      <c:pt idx="39">
                        <c:v>15.579621298309902</c:v>
                      </c:pt>
                      <c:pt idx="40">
                        <c:v>66.720942505984766</c:v>
                      </c:pt>
                      <c:pt idx="41">
                        <c:v>109.42165949027464</c:v>
                      </c:pt>
                      <c:pt idx="42">
                        <c:v>153.01280145187721</c:v>
                      </c:pt>
                      <c:pt idx="43">
                        <c:v>84.825909263401016</c:v>
                      </c:pt>
                      <c:pt idx="44">
                        <c:v>25.858167120299733</c:v>
                      </c:pt>
                      <c:pt idx="45">
                        <c:v>102.04505930877568</c:v>
                      </c:pt>
                      <c:pt idx="46">
                        <c:v>55.239375567069864</c:v>
                      </c:pt>
                      <c:pt idx="47">
                        <c:v>137.93087602081701</c:v>
                      </c:pt>
                      <c:pt idx="48">
                        <c:v>120.17306739254796</c:v>
                      </c:pt>
                      <c:pt idx="49">
                        <c:v>163.34664645712155</c:v>
                      </c:pt>
                      <c:pt idx="50">
                        <c:v>271.3172044047692</c:v>
                      </c:pt>
                      <c:pt idx="51">
                        <c:v>223.89426412556588</c:v>
                      </c:pt>
                      <c:pt idx="52">
                        <c:v>-143.38402746950575</c:v>
                      </c:pt>
                      <c:pt idx="53">
                        <c:v>664.76625604179048</c:v>
                      </c:pt>
                      <c:pt idx="54">
                        <c:v>896.27777670496766</c:v>
                      </c:pt>
                      <c:pt idx="55">
                        <c:v>1391.5742439161302</c:v>
                      </c:pt>
                      <c:pt idx="56">
                        <c:v>1517.9467475042682</c:v>
                      </c:pt>
                      <c:pt idx="57">
                        <c:v>1212.0222722093331</c:v>
                      </c:pt>
                      <c:pt idx="58">
                        <c:v>1058.8435732075777</c:v>
                      </c:pt>
                      <c:pt idx="59">
                        <c:v>860.50511993706323</c:v>
                      </c:pt>
                      <c:pt idx="60">
                        <c:v>788.52534545887352</c:v>
                      </c:pt>
                      <c:pt idx="61">
                        <c:v>607.56400404176941</c:v>
                      </c:pt>
                      <c:pt idx="62">
                        <c:v>495.8696877834758</c:v>
                      </c:pt>
                      <c:pt idx="63">
                        <c:v>319.82232434195055</c:v>
                      </c:pt>
                      <c:pt idx="64">
                        <c:v>376.82411680267512</c:v>
                      </c:pt>
                      <c:pt idx="65">
                        <c:v>241.72145417789503</c:v>
                      </c:pt>
                      <c:pt idx="66">
                        <c:v>291.59523855484747</c:v>
                      </c:pt>
                      <c:pt idx="67">
                        <c:v>131.70762938208173</c:v>
                      </c:pt>
                      <c:pt idx="68">
                        <c:v>124.912954631643</c:v>
                      </c:pt>
                      <c:pt idx="69">
                        <c:v>-148.52893038055532</c:v>
                      </c:pt>
                      <c:pt idx="70">
                        <c:v>0</c:v>
                      </c:pt>
                      <c:pt idx="71">
                        <c:v>148.6385054030136</c:v>
                      </c:pt>
                      <c:pt idx="72">
                        <c:v>122.09063028957671</c:v>
                      </c:pt>
                      <c:pt idx="73">
                        <c:v>79.106759218026014</c:v>
                      </c:pt>
                      <c:pt idx="74">
                        <c:v>46.565796502495999</c:v>
                      </c:pt>
                      <c:pt idx="75">
                        <c:v>20.353558855028339</c:v>
                      </c:pt>
                      <c:pt idx="76">
                        <c:v>59.444700816630693</c:v>
                      </c:pt>
                      <c:pt idx="77">
                        <c:v>7.3033796089558116</c:v>
                      </c:pt>
                      <c:pt idx="78">
                        <c:v>23.851254722392689</c:v>
                      </c:pt>
                      <c:pt idx="79">
                        <c:v>17.965438010351281</c:v>
                      </c:pt>
                      <c:pt idx="80">
                        <c:v>-203.86917611179513</c:v>
                      </c:pt>
                      <c:pt idx="81">
                        <c:v>-110.08192543117467</c:v>
                      </c:pt>
                      <c:pt idx="82">
                        <c:v>-138.34664645735029</c:v>
                      </c:pt>
                      <c:pt idx="83">
                        <c:v>-219.58371789189894</c:v>
                      </c:pt>
                      <c:pt idx="84">
                        <c:v>-248.06989309608511</c:v>
                      </c:pt>
                      <c:pt idx="85">
                        <c:v>41.453917347173018</c:v>
                      </c:pt>
                      <c:pt idx="86">
                        <c:v>1.696108718903778</c:v>
                      </c:pt>
                      <c:pt idx="87">
                        <c:v>109.41935535763872</c:v>
                      </c:pt>
                      <c:pt idx="88">
                        <c:v>67.38530504001605</c:v>
                      </c:pt>
                      <c:pt idx="89">
                        <c:v>-18.29467475055332</c:v>
                      </c:pt>
                      <c:pt idx="90">
                        <c:v>-82.929083560321274</c:v>
                      </c:pt>
                      <c:pt idx="91">
                        <c:v>15.579621298309902</c:v>
                      </c:pt>
                      <c:pt idx="92">
                        <c:v>66.720942505984766</c:v>
                      </c:pt>
                      <c:pt idx="93">
                        <c:v>109.42165949027464</c:v>
                      </c:pt>
                      <c:pt idx="94">
                        <c:v>153.01280145187721</c:v>
                      </c:pt>
                      <c:pt idx="95">
                        <c:v>84.825909263401016</c:v>
                      </c:pt>
                      <c:pt idx="96">
                        <c:v>25.858167120299733</c:v>
                      </c:pt>
                      <c:pt idx="97">
                        <c:v>102.04505930877568</c:v>
                      </c:pt>
                      <c:pt idx="98">
                        <c:v>55.239375567069864</c:v>
                      </c:pt>
                      <c:pt idx="99">
                        <c:v>137.93087602081701</c:v>
                      </c:pt>
                      <c:pt idx="100">
                        <c:v>120.17306739254796</c:v>
                      </c:pt>
                      <c:pt idx="101">
                        <c:v>163.34664645712155</c:v>
                      </c:pt>
                      <c:pt idx="102">
                        <c:v>271.3172044047692</c:v>
                      </c:pt>
                      <c:pt idx="103">
                        <c:v>223.89426412556588</c:v>
                      </c:pt>
                      <c:pt idx="104">
                        <c:v>-143.38402746950575</c:v>
                      </c:pt>
                      <c:pt idx="105">
                        <c:v>664.76625604179048</c:v>
                      </c:pt>
                      <c:pt idx="106">
                        <c:v>896.27777670496766</c:v>
                      </c:pt>
                      <c:pt idx="107">
                        <c:v>1391.5742439161302</c:v>
                      </c:pt>
                      <c:pt idx="108">
                        <c:v>1517.9467475042682</c:v>
                      </c:pt>
                      <c:pt idx="109">
                        <c:v>1212.0222722093331</c:v>
                      </c:pt>
                      <c:pt idx="110">
                        <c:v>1058.8435732075777</c:v>
                      </c:pt>
                      <c:pt idx="111">
                        <c:v>860.50511993706323</c:v>
                      </c:pt>
                      <c:pt idx="112">
                        <c:v>788.52534545887352</c:v>
                      </c:pt>
                      <c:pt idx="113">
                        <c:v>607.56400404176941</c:v>
                      </c:pt>
                      <c:pt idx="114">
                        <c:v>495.8696877834758</c:v>
                      </c:pt>
                      <c:pt idx="115">
                        <c:v>319.82232434195055</c:v>
                      </c:pt>
                      <c:pt idx="116">
                        <c:v>376.82411680267512</c:v>
                      </c:pt>
                      <c:pt idx="117">
                        <c:v>241.72145417789503</c:v>
                      </c:pt>
                      <c:pt idx="118">
                        <c:v>291.59523855484747</c:v>
                      </c:pt>
                      <c:pt idx="119">
                        <c:v>131.70762938208173</c:v>
                      </c:pt>
                      <c:pt idx="120">
                        <c:v>124.912954631643</c:v>
                      </c:pt>
                      <c:pt idx="121">
                        <c:v>-148.52893038055532</c:v>
                      </c:pt>
                      <c:pt idx="122">
                        <c:v>0</c:v>
                      </c:pt>
                      <c:pt idx="123">
                        <c:v>148.6385054030136</c:v>
                      </c:pt>
                      <c:pt idx="124">
                        <c:v>122.09063028957671</c:v>
                      </c:pt>
                      <c:pt idx="125">
                        <c:v>79.106759218026014</c:v>
                      </c:pt>
                      <c:pt idx="126">
                        <c:v>46.565796502495999</c:v>
                      </c:pt>
                      <c:pt idx="127">
                        <c:v>20.353558855028339</c:v>
                      </c:pt>
                      <c:pt idx="128">
                        <c:v>59.444700816630693</c:v>
                      </c:pt>
                      <c:pt idx="129">
                        <c:v>7.3033796089558116</c:v>
                      </c:pt>
                      <c:pt idx="130">
                        <c:v>23.851254722392689</c:v>
                      </c:pt>
                      <c:pt idx="131">
                        <c:v>17.965438010351281</c:v>
                      </c:pt>
                      <c:pt idx="132">
                        <c:v>-203.86917611179513</c:v>
                      </c:pt>
                      <c:pt idx="133">
                        <c:v>-110.08192543117467</c:v>
                      </c:pt>
                      <c:pt idx="134">
                        <c:v>-138.34664645735029</c:v>
                      </c:pt>
                      <c:pt idx="135">
                        <c:v>-219.58371789189894</c:v>
                      </c:pt>
                      <c:pt idx="136">
                        <c:v>-248.06989309608511</c:v>
                      </c:pt>
                      <c:pt idx="137">
                        <c:v>41.453917347173018</c:v>
                      </c:pt>
                      <c:pt idx="138">
                        <c:v>1.696108718903778</c:v>
                      </c:pt>
                      <c:pt idx="139">
                        <c:v>109.41935535763872</c:v>
                      </c:pt>
                      <c:pt idx="140">
                        <c:v>67.38530504001605</c:v>
                      </c:pt>
                      <c:pt idx="141">
                        <c:v>-18.29467475055332</c:v>
                      </c:pt>
                      <c:pt idx="142">
                        <c:v>-82.929083560321274</c:v>
                      </c:pt>
                      <c:pt idx="143">
                        <c:v>15.579621298309902</c:v>
                      </c:pt>
                      <c:pt idx="144">
                        <c:v>66.720942505984766</c:v>
                      </c:pt>
                      <c:pt idx="145">
                        <c:v>109.42165949027464</c:v>
                      </c:pt>
                      <c:pt idx="146">
                        <c:v>153.01280145187721</c:v>
                      </c:pt>
                      <c:pt idx="147">
                        <c:v>84.825909263401016</c:v>
                      </c:pt>
                      <c:pt idx="148">
                        <c:v>25.858167120299733</c:v>
                      </c:pt>
                      <c:pt idx="149">
                        <c:v>102.04505930877568</c:v>
                      </c:pt>
                      <c:pt idx="150">
                        <c:v>55.239375567069864</c:v>
                      </c:pt>
                      <c:pt idx="151">
                        <c:v>137.93087602081701</c:v>
                      </c:pt>
                      <c:pt idx="152">
                        <c:v>120.17306739254796</c:v>
                      </c:pt>
                      <c:pt idx="153">
                        <c:v>163.34664645712155</c:v>
                      </c:pt>
                      <c:pt idx="154">
                        <c:v>271.3172044047692</c:v>
                      </c:pt>
                      <c:pt idx="155">
                        <c:v>223.89426412556588</c:v>
                      </c:pt>
                      <c:pt idx="156">
                        <c:v>-143.38402746950575</c:v>
                      </c:pt>
                      <c:pt idx="157">
                        <c:v>664.76625604179048</c:v>
                      </c:pt>
                      <c:pt idx="158">
                        <c:v>896.27777670496766</c:v>
                      </c:pt>
                      <c:pt idx="159">
                        <c:v>1391.5742439161302</c:v>
                      </c:pt>
                      <c:pt idx="160">
                        <c:v>1517.9467475042682</c:v>
                      </c:pt>
                      <c:pt idx="161">
                        <c:v>1212.0222722093331</c:v>
                      </c:pt>
                      <c:pt idx="162">
                        <c:v>1058.8435732075777</c:v>
                      </c:pt>
                      <c:pt idx="163">
                        <c:v>860.50511993706323</c:v>
                      </c:pt>
                      <c:pt idx="164">
                        <c:v>788.52534545887352</c:v>
                      </c:pt>
                      <c:pt idx="165">
                        <c:v>607.56400404176941</c:v>
                      </c:pt>
                      <c:pt idx="166">
                        <c:v>495.8696877834758</c:v>
                      </c:pt>
                      <c:pt idx="167">
                        <c:v>319.82232434195055</c:v>
                      </c:pt>
                      <c:pt idx="168">
                        <c:v>376.82411680267512</c:v>
                      </c:pt>
                      <c:pt idx="169">
                        <c:v>241.72145417789503</c:v>
                      </c:pt>
                      <c:pt idx="170">
                        <c:v>291.59523855484747</c:v>
                      </c:pt>
                      <c:pt idx="171">
                        <c:v>131.70762938208173</c:v>
                      </c:pt>
                      <c:pt idx="172">
                        <c:v>124.912954631643</c:v>
                      </c:pt>
                      <c:pt idx="173">
                        <c:v>-148.52893038055532</c:v>
                      </c:pt>
                      <c:pt idx="174">
                        <c:v>0</c:v>
                      </c:pt>
                      <c:pt idx="175">
                        <c:v>148.6385054030136</c:v>
                      </c:pt>
                      <c:pt idx="176">
                        <c:v>122.09063028957671</c:v>
                      </c:pt>
                      <c:pt idx="177">
                        <c:v>79.106759218026014</c:v>
                      </c:pt>
                      <c:pt idx="178">
                        <c:v>46.565796502495999</c:v>
                      </c:pt>
                      <c:pt idx="179">
                        <c:v>20.353558855028339</c:v>
                      </c:pt>
                      <c:pt idx="180">
                        <c:v>59.444700816630693</c:v>
                      </c:pt>
                      <c:pt idx="181">
                        <c:v>7.3033796089558116</c:v>
                      </c:pt>
                      <c:pt idx="182">
                        <c:v>23.851254722392689</c:v>
                      </c:pt>
                      <c:pt idx="183">
                        <c:v>17.965438010351281</c:v>
                      </c:pt>
                      <c:pt idx="184">
                        <c:v>-203.86917611179513</c:v>
                      </c:pt>
                      <c:pt idx="185">
                        <c:v>-110.08192543117467</c:v>
                      </c:pt>
                      <c:pt idx="186">
                        <c:v>-138.34664645735029</c:v>
                      </c:pt>
                      <c:pt idx="187">
                        <c:v>-219.58371789189894</c:v>
                      </c:pt>
                      <c:pt idx="188">
                        <c:v>-248.06989309608511</c:v>
                      </c:pt>
                      <c:pt idx="189">
                        <c:v>41.453917347173018</c:v>
                      </c:pt>
                      <c:pt idx="190">
                        <c:v>1.696108718903778</c:v>
                      </c:pt>
                      <c:pt idx="191">
                        <c:v>109.41935535763872</c:v>
                      </c:pt>
                      <c:pt idx="192">
                        <c:v>67.38530504001605</c:v>
                      </c:pt>
                      <c:pt idx="193">
                        <c:v>-18.29467475055332</c:v>
                      </c:pt>
                      <c:pt idx="194">
                        <c:v>-82.929083560321274</c:v>
                      </c:pt>
                      <c:pt idx="195">
                        <c:v>15.579621298309902</c:v>
                      </c:pt>
                      <c:pt idx="196">
                        <c:v>66.720942505984766</c:v>
                      </c:pt>
                      <c:pt idx="197">
                        <c:v>109.42165949027464</c:v>
                      </c:pt>
                      <c:pt idx="198">
                        <c:v>153.01280145187721</c:v>
                      </c:pt>
                      <c:pt idx="199">
                        <c:v>84.825909263401016</c:v>
                      </c:pt>
                      <c:pt idx="200">
                        <c:v>25.858167120299733</c:v>
                      </c:pt>
                      <c:pt idx="201">
                        <c:v>102.04505930877568</c:v>
                      </c:pt>
                      <c:pt idx="202">
                        <c:v>55.239375567069864</c:v>
                      </c:pt>
                      <c:pt idx="203">
                        <c:v>137.93087602081701</c:v>
                      </c:pt>
                      <c:pt idx="204">
                        <c:v>120.17306739254796</c:v>
                      </c:pt>
                      <c:pt idx="205">
                        <c:v>163.34664645712155</c:v>
                      </c:pt>
                      <c:pt idx="206">
                        <c:v>271.3172044047692</c:v>
                      </c:pt>
                      <c:pt idx="207">
                        <c:v>223.89426412556588</c:v>
                      </c:pt>
                      <c:pt idx="208">
                        <c:v>-525.93113346603639</c:v>
                      </c:pt>
                      <c:pt idx="209">
                        <c:v>-143.38402746950575</c:v>
                      </c:pt>
                      <c:pt idx="210">
                        <c:v>664.76625604179048</c:v>
                      </c:pt>
                      <c:pt idx="211">
                        <c:v>896.27777670496766</c:v>
                      </c:pt>
                      <c:pt idx="212">
                        <c:v>1391.5742439161302</c:v>
                      </c:pt>
                      <c:pt idx="213">
                        <c:v>1517.9467475042682</c:v>
                      </c:pt>
                      <c:pt idx="214">
                        <c:v>1212.0222722093331</c:v>
                      </c:pt>
                      <c:pt idx="215">
                        <c:v>1058.8435732075777</c:v>
                      </c:pt>
                      <c:pt idx="216">
                        <c:v>860.50511993706323</c:v>
                      </c:pt>
                      <c:pt idx="217">
                        <c:v>788.52534545887352</c:v>
                      </c:pt>
                      <c:pt idx="218">
                        <c:v>607.56400404176941</c:v>
                      </c:pt>
                      <c:pt idx="219">
                        <c:v>495.8696877834758</c:v>
                      </c:pt>
                      <c:pt idx="220">
                        <c:v>319.82232434195055</c:v>
                      </c:pt>
                      <c:pt idx="221">
                        <c:v>376.82411680267512</c:v>
                      </c:pt>
                      <c:pt idx="222">
                        <c:v>241.72145417789503</c:v>
                      </c:pt>
                      <c:pt idx="223">
                        <c:v>291.59523855484747</c:v>
                      </c:pt>
                      <c:pt idx="224">
                        <c:v>131.70762938208173</c:v>
                      </c:pt>
                      <c:pt idx="225">
                        <c:v>124.912954631643</c:v>
                      </c:pt>
                      <c:pt idx="226">
                        <c:v>-148.52893038055532</c:v>
                      </c:pt>
                      <c:pt idx="227">
                        <c:v>0</c:v>
                      </c:pt>
                      <c:pt idx="228">
                        <c:v>148.6385054030136</c:v>
                      </c:pt>
                      <c:pt idx="229">
                        <c:v>122.09063028957671</c:v>
                      </c:pt>
                      <c:pt idx="230">
                        <c:v>79.106759218026014</c:v>
                      </c:pt>
                      <c:pt idx="231">
                        <c:v>46.565796502495999</c:v>
                      </c:pt>
                      <c:pt idx="232">
                        <c:v>20.353558855028339</c:v>
                      </c:pt>
                      <c:pt idx="233">
                        <c:v>59.444700816630693</c:v>
                      </c:pt>
                      <c:pt idx="234">
                        <c:v>7.3033796089558116</c:v>
                      </c:pt>
                      <c:pt idx="235">
                        <c:v>23.851254722392689</c:v>
                      </c:pt>
                      <c:pt idx="236">
                        <c:v>17.965438010351281</c:v>
                      </c:pt>
                      <c:pt idx="237">
                        <c:v>-203.86917611179513</c:v>
                      </c:pt>
                      <c:pt idx="238">
                        <c:v>-110.08192543117467</c:v>
                      </c:pt>
                      <c:pt idx="239">
                        <c:v>-138.34664645735029</c:v>
                      </c:pt>
                      <c:pt idx="240">
                        <c:v>-219.58371789189894</c:v>
                      </c:pt>
                      <c:pt idx="241">
                        <c:v>-248.06989309608511</c:v>
                      </c:pt>
                      <c:pt idx="242">
                        <c:v>41.453917347173018</c:v>
                      </c:pt>
                      <c:pt idx="243">
                        <c:v>1.696108718903778</c:v>
                      </c:pt>
                      <c:pt idx="244">
                        <c:v>109.41935535763872</c:v>
                      </c:pt>
                      <c:pt idx="245">
                        <c:v>67.38530504001605</c:v>
                      </c:pt>
                      <c:pt idx="246">
                        <c:v>-18.29467475055332</c:v>
                      </c:pt>
                      <c:pt idx="247">
                        <c:v>-82.929083560321274</c:v>
                      </c:pt>
                      <c:pt idx="248">
                        <c:v>15.579621298309902</c:v>
                      </c:pt>
                      <c:pt idx="249">
                        <c:v>66.720942505984766</c:v>
                      </c:pt>
                      <c:pt idx="250">
                        <c:v>109.42165949027464</c:v>
                      </c:pt>
                      <c:pt idx="251">
                        <c:v>153.01280145187721</c:v>
                      </c:pt>
                      <c:pt idx="252">
                        <c:v>84.825909263401016</c:v>
                      </c:pt>
                      <c:pt idx="253">
                        <c:v>25.858167120299733</c:v>
                      </c:pt>
                      <c:pt idx="254">
                        <c:v>102.04505930877568</c:v>
                      </c:pt>
                      <c:pt idx="255">
                        <c:v>55.239375567069864</c:v>
                      </c:pt>
                      <c:pt idx="256">
                        <c:v>137.93087602081701</c:v>
                      </c:pt>
                      <c:pt idx="257">
                        <c:v>120.17306739254796</c:v>
                      </c:pt>
                      <c:pt idx="258">
                        <c:v>163.34664645712155</c:v>
                      </c:pt>
                      <c:pt idx="259">
                        <c:v>271.3172044047692</c:v>
                      </c:pt>
                      <c:pt idx="260">
                        <c:v>223.89426412556588</c:v>
                      </c:pt>
                      <c:pt idx="261">
                        <c:v>-143.38402746950575</c:v>
                      </c:pt>
                      <c:pt idx="262">
                        <c:v>664.76625604179048</c:v>
                      </c:pt>
                      <c:pt idx="263">
                        <c:v>896.27777670496766</c:v>
                      </c:pt>
                      <c:pt idx="264">
                        <c:v>1391.5742439161302</c:v>
                      </c:pt>
                      <c:pt idx="265">
                        <c:v>1517.9467475042682</c:v>
                      </c:pt>
                      <c:pt idx="266">
                        <c:v>1212.0222722093331</c:v>
                      </c:pt>
                      <c:pt idx="267">
                        <c:v>1058.8435732075777</c:v>
                      </c:pt>
                      <c:pt idx="268">
                        <c:v>860.50511993706323</c:v>
                      </c:pt>
                      <c:pt idx="269">
                        <c:v>788.52534545887352</c:v>
                      </c:pt>
                      <c:pt idx="270">
                        <c:v>607.56400404176941</c:v>
                      </c:pt>
                      <c:pt idx="271">
                        <c:v>495.8696877834758</c:v>
                      </c:pt>
                      <c:pt idx="272">
                        <c:v>319.82232434195055</c:v>
                      </c:pt>
                      <c:pt idx="273">
                        <c:v>376.82411680267512</c:v>
                      </c:pt>
                      <c:pt idx="274">
                        <c:v>241.72145417789503</c:v>
                      </c:pt>
                      <c:pt idx="275">
                        <c:v>291.59523855484747</c:v>
                      </c:pt>
                      <c:pt idx="276">
                        <c:v>131.70762938208173</c:v>
                      </c:pt>
                      <c:pt idx="277">
                        <c:v>124.912954631643</c:v>
                      </c:pt>
                      <c:pt idx="278">
                        <c:v>-148.52893038055532</c:v>
                      </c:pt>
                      <c:pt idx="279">
                        <c:v>0</c:v>
                      </c:pt>
                      <c:pt idx="280">
                        <c:v>148.6385054030136</c:v>
                      </c:pt>
                      <c:pt idx="281">
                        <c:v>122.09063028957671</c:v>
                      </c:pt>
                      <c:pt idx="282">
                        <c:v>79.106759218026014</c:v>
                      </c:pt>
                      <c:pt idx="283">
                        <c:v>46.565796502495999</c:v>
                      </c:pt>
                      <c:pt idx="284">
                        <c:v>20.353558855028339</c:v>
                      </c:pt>
                      <c:pt idx="285">
                        <c:v>59.444700816630693</c:v>
                      </c:pt>
                      <c:pt idx="286">
                        <c:v>7.3033796089558116</c:v>
                      </c:pt>
                      <c:pt idx="287">
                        <c:v>23.851254722392689</c:v>
                      </c:pt>
                      <c:pt idx="288">
                        <c:v>17.965438010351281</c:v>
                      </c:pt>
                      <c:pt idx="289">
                        <c:v>-203.86917611179513</c:v>
                      </c:pt>
                      <c:pt idx="290">
                        <c:v>-110.08192543117467</c:v>
                      </c:pt>
                      <c:pt idx="291">
                        <c:v>-138.34664645735029</c:v>
                      </c:pt>
                      <c:pt idx="292">
                        <c:v>-219.58371789189894</c:v>
                      </c:pt>
                      <c:pt idx="293">
                        <c:v>-248.06989309608511</c:v>
                      </c:pt>
                      <c:pt idx="294">
                        <c:v>41.453917347173018</c:v>
                      </c:pt>
                      <c:pt idx="295">
                        <c:v>1.696108718903778</c:v>
                      </c:pt>
                      <c:pt idx="296">
                        <c:v>109.41935535763872</c:v>
                      </c:pt>
                      <c:pt idx="297">
                        <c:v>67.38530504001605</c:v>
                      </c:pt>
                      <c:pt idx="298">
                        <c:v>-18.29467475055332</c:v>
                      </c:pt>
                      <c:pt idx="299">
                        <c:v>-82.929083560321274</c:v>
                      </c:pt>
                      <c:pt idx="300">
                        <c:v>15.579621298309902</c:v>
                      </c:pt>
                      <c:pt idx="301">
                        <c:v>66.720942505984766</c:v>
                      </c:pt>
                      <c:pt idx="302">
                        <c:v>109.42165949027464</c:v>
                      </c:pt>
                      <c:pt idx="303">
                        <c:v>153.01280145187721</c:v>
                      </c:pt>
                      <c:pt idx="304">
                        <c:v>84.825909263401016</c:v>
                      </c:pt>
                      <c:pt idx="305">
                        <c:v>25.858167120299733</c:v>
                      </c:pt>
                      <c:pt idx="306">
                        <c:v>102.04505930877568</c:v>
                      </c:pt>
                      <c:pt idx="307">
                        <c:v>55.239375567069864</c:v>
                      </c:pt>
                      <c:pt idx="308">
                        <c:v>137.93087602081701</c:v>
                      </c:pt>
                      <c:pt idx="309">
                        <c:v>120.17306739254796</c:v>
                      </c:pt>
                      <c:pt idx="310">
                        <c:v>163.34664645712155</c:v>
                      </c:pt>
                      <c:pt idx="311">
                        <c:v>271.3172044047692</c:v>
                      </c:pt>
                      <c:pt idx="312">
                        <c:v>223.89426412556588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B3D-4EC0-A8D6-5E64F831BF17}"/>
                  </c:ext>
                </c:extLst>
              </c15:ser>
            </c15:filteredLineSeries>
          </c:ext>
        </c:extLst>
      </c:lineChart>
      <c:catAx>
        <c:axId val="1627113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6116352"/>
        <c:crosses val="autoZero"/>
        <c:auto val="1"/>
        <c:lblAlgn val="ctr"/>
        <c:lblOffset val="100"/>
        <c:noMultiLvlLbl val="0"/>
      </c:catAx>
      <c:valAx>
        <c:axId val="1626116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influenza case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7113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405946173085094"/>
          <c:y val="0.87306911636045492"/>
          <c:w val="0.3543453786150203"/>
          <c:h val="0.11767162438028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701</cdr:x>
      <cdr:y>0.01822</cdr:y>
    </cdr:from>
    <cdr:to>
      <cdr:x>0.9879</cdr:x>
      <cdr:y>0.07407</cdr:y>
    </cdr:to>
    <cdr:sp macro="" textlink="">
      <cdr:nvSpPr>
        <cdr:cNvPr id="2" name="タイトル 2"/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124980"/>
          <a:ext cx="10515600" cy="38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 fontScale="90000"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kumimoji="1"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Sample Figure </a:t>
          </a:r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endParaRPr kumimoji="1" lang="ja-JP" alt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78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17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63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46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264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85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3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18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09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76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3742227777"/>
              </p:ext>
            </p:extLst>
          </p:nvPr>
        </p:nvGraphicFramePr>
        <p:xfrm>
          <a:off x="333375" y="0"/>
          <a:ext cx="1154429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5122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6</TotalTime>
  <Words>11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yama Yusuke</dc:creator>
  <cp:lastModifiedBy>Katayama Yusuke</cp:lastModifiedBy>
  <cp:revision>6</cp:revision>
  <dcterms:created xsi:type="dcterms:W3CDTF">2020-03-26T05:47:16Z</dcterms:created>
  <dcterms:modified xsi:type="dcterms:W3CDTF">2020-04-01T03:48:03Z</dcterms:modified>
</cp:coreProperties>
</file>